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s/slide10.xml" ContentType="application/vnd.openxmlformats-officedocument.presentationml.slide+xml"/>
  <Override PartName="/ppt/slides/slide12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1.xml" ContentType="application/vnd.openxmlformats-officedocument.presentationml.slide+xml"/>
  <Override PartName="/ppt/slides/slide20.xml" ContentType="application/vnd.openxmlformats-officedocument.presentationml.slide+xml"/>
  <Override PartName="/ppt/slideLayouts/slideLayout10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89" r:id="rId2"/>
    <p:sldId id="298" r:id="rId3"/>
    <p:sldId id="296" r:id="rId4"/>
    <p:sldId id="297" r:id="rId5"/>
    <p:sldId id="299" r:id="rId6"/>
    <p:sldId id="300" r:id="rId7"/>
    <p:sldId id="301" r:id="rId8"/>
    <p:sldId id="302" r:id="rId9"/>
    <p:sldId id="303" r:id="rId10"/>
    <p:sldId id="304" r:id="rId11"/>
    <p:sldId id="305" r:id="rId12"/>
    <p:sldId id="306" r:id="rId13"/>
    <p:sldId id="307" r:id="rId14"/>
    <p:sldId id="308" r:id="rId15"/>
    <p:sldId id="288" r:id="rId16"/>
    <p:sldId id="293" r:id="rId17"/>
    <p:sldId id="294" r:id="rId18"/>
    <p:sldId id="295" r:id="rId19"/>
    <p:sldId id="290" r:id="rId20"/>
    <p:sldId id="291" r:id="rId21"/>
    <p:sldId id="292" r:id="rId2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3A33DEFC-212C-4CBD-9993-26D1062B6AC7}">
          <p14:sldIdLst>
            <p14:sldId id="289"/>
            <p14:sldId id="298"/>
            <p14:sldId id="296"/>
            <p14:sldId id="297"/>
            <p14:sldId id="299"/>
            <p14:sldId id="300"/>
            <p14:sldId id="301"/>
            <p14:sldId id="302"/>
            <p14:sldId id="303"/>
            <p14:sldId id="304"/>
            <p14:sldId id="305"/>
            <p14:sldId id="306"/>
            <p14:sldId id="307"/>
            <p14:sldId id="308"/>
            <p14:sldId id="288"/>
            <p14:sldId id="293"/>
            <p14:sldId id="294"/>
            <p14:sldId id="295"/>
            <p14:sldId id="290"/>
            <p14:sldId id="291"/>
            <p14:sldId id="292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99"/>
    <a:srgbClr val="0000FF"/>
    <a:srgbClr val="009900"/>
    <a:srgbClr val="33B355"/>
    <a:srgbClr val="37C96F"/>
    <a:srgbClr val="FF6699"/>
    <a:srgbClr val="00FFFF"/>
    <a:srgbClr val="FF990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94" autoAdjust="0"/>
    <p:restoredTop sz="99816" autoAdjust="0"/>
  </p:normalViewPr>
  <p:slideViewPr>
    <p:cSldViewPr>
      <p:cViewPr>
        <p:scale>
          <a:sx n="64" d="100"/>
          <a:sy n="64" d="100"/>
        </p:scale>
        <p:origin x="-1596" y="-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customXml" Target="../customXml/item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28" Type="http://schemas.openxmlformats.org/officeDocument/2006/relationships/customXml" Target="../customXml/item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Relationship Id="rId30" Type="http://schemas.openxmlformats.org/officeDocument/2006/relationships/customXml" Target="../customXml/item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0A99FD-8EF8-4865-85C7-3B67C7CFF430}" type="datetimeFigureOut">
              <a:rPr lang="zh-CN" altLang="en-US" smtClean="0"/>
              <a:t>2015/4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9C5EE5-DBE1-4B2A-8A79-E7A96D3B6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0481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FD6ECC-CB73-42CD-B55F-D8840F2209EF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28873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E07FD5-C621-4D6A-AA79-5B36F6C81C7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6512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E07FD5-C621-4D6A-AA79-5B36F6C81C71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8124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5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jpeg"/><Relationship Id="rId7" Type="http://schemas.openxmlformats.org/officeDocument/2006/relationships/image" Target="../media/image44.png"/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-36512" y="44624"/>
            <a:ext cx="3277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ig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-9216" y="404664"/>
            <a:ext cx="4248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2" descr="C:\Users\zhangyanan\Desktop\原理图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804724"/>
            <a:ext cx="5419248" cy="40644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345790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zhangyanan\AppData\Roaming\Tencent\Users\851434558\QQ\WinTemp\RichOle\{)TC$$SCXG@~S_MP_7{87YQ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831523"/>
            <a:ext cx="924477" cy="27484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63688" y="122364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 flipH="1">
            <a:off x="1600240" y="1420341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10058" y="62105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01991" y="626948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80743" y="618274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74961" y="67011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858294" y="67011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83373" y="670116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76976" y="67011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122479" y="67247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03981" y="3977768"/>
            <a:ext cx="83498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20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                             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0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)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727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488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</a:t>
            </a: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95" name="Picture 3" descr="C:\Users\zhangyanan\AppData\Roaming\Tencent\Users\851434558\QQ\WinTemp\RichOle\R8~IBLH099KW)4)VR8AY)[H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845350"/>
            <a:ext cx="1008112" cy="27347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直接箭头连接符 17"/>
          <p:cNvCxnSpPr/>
          <p:nvPr/>
        </p:nvCxnSpPr>
        <p:spPr>
          <a:xfrm>
            <a:off x="2339373" y="1412776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7222849" y="1196752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箭头连接符 21"/>
          <p:cNvCxnSpPr/>
          <p:nvPr/>
        </p:nvCxnSpPr>
        <p:spPr>
          <a:xfrm flipH="1">
            <a:off x="7059401" y="1393447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6046226" y="63413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374599" y="63413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687126" y="638618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zhangyanan\Desktop\修图\2\1202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1016" y="876343"/>
            <a:ext cx="2810592" cy="27329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左大括号 25"/>
          <p:cNvSpPr/>
          <p:nvPr/>
        </p:nvSpPr>
        <p:spPr>
          <a:xfrm rot="16200000">
            <a:off x="845284" y="1349794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左大括号 26"/>
          <p:cNvSpPr/>
          <p:nvPr/>
        </p:nvSpPr>
        <p:spPr>
          <a:xfrm rot="16200000">
            <a:off x="3785256" y="1706152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左大括号 27"/>
          <p:cNvSpPr/>
          <p:nvPr/>
        </p:nvSpPr>
        <p:spPr>
          <a:xfrm rot="16200000">
            <a:off x="5032093" y="1356335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左大括号 28"/>
          <p:cNvSpPr/>
          <p:nvPr/>
        </p:nvSpPr>
        <p:spPr>
          <a:xfrm rot="16200000">
            <a:off x="6317893" y="1300367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4432" y="99216"/>
            <a:ext cx="4283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99663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1" name="Picture 1" descr="C:\Users\zhangyanan\AppData\Roaming\Tencent\Users\851434558\QQ\WinTemp\RichOle\JU~Z$GSVRU@(ID124BVH]8H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7711" y="1468516"/>
            <a:ext cx="1692601" cy="3218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7" name="Picture 1" descr="C:\Users\zhangyanan\AppData\Roaming\Tencent\Users\851434558\QQ\WinTemp\RichOle\~VE@[~E3QD[TV$XRBM_V98T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022" y="1442916"/>
            <a:ext cx="1190666" cy="3281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8" name="Picture 2" descr="C:\Users\zhangyanan\AppData\Roaming\Tencent\Users\851434558\QQ\WinTemp\RichOle\`TT4KXYC0JKK4DQFJ9UH}WX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800" y="1435112"/>
            <a:ext cx="1152128" cy="3251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927136" y="1966101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 flipH="1">
            <a:off x="1763688" y="2162796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126505" y="201573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flipH="1">
            <a:off x="3963057" y="2212429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36952" y="1240048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32560" y="123358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78547" y="1237272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832760" y="122473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230742" y="122473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0573" y="4926646"/>
            <a:ext cx="83498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slr1087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509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                      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457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</a:t>
            </a: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563888" y="1237093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652120" y="1264838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910436" y="1264838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078945" y="1260086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左大括号 24"/>
          <p:cNvSpPr/>
          <p:nvPr/>
        </p:nvSpPr>
        <p:spPr>
          <a:xfrm rot="16200000">
            <a:off x="907069" y="2076415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左大括号 25"/>
          <p:cNvSpPr/>
          <p:nvPr/>
        </p:nvSpPr>
        <p:spPr>
          <a:xfrm rot="16200000">
            <a:off x="3137184" y="2136066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左大括号 26"/>
          <p:cNvSpPr/>
          <p:nvPr/>
        </p:nvSpPr>
        <p:spPr>
          <a:xfrm rot="16200000">
            <a:off x="5916084" y="2311703"/>
            <a:ext cx="72084" cy="343334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7"/>
          <p:cNvSpPr txBox="1"/>
          <p:nvPr/>
        </p:nvSpPr>
        <p:spPr>
          <a:xfrm>
            <a:off x="7577286" y="220623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箭头连接符 28"/>
          <p:cNvCxnSpPr/>
          <p:nvPr/>
        </p:nvCxnSpPr>
        <p:spPr>
          <a:xfrm flipH="1">
            <a:off x="7413838" y="2402929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矩形 23"/>
          <p:cNvSpPr/>
          <p:nvPr/>
        </p:nvSpPr>
        <p:spPr>
          <a:xfrm>
            <a:off x="4432" y="99216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J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07180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1" name="Picture 1" descr="C:\Users\zhangyanan\AppData\Roaming\Tencent\Users\851434558\QQ\WinTemp\RichOle\D_U4A[BUAOJZ3LJ04M%H`3H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608" y="1124743"/>
            <a:ext cx="2448272" cy="2553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9512" y="1745922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>
            <a:off x="755197" y="1935052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070502" y="926940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92600" y="92216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52640" y="92216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12680" y="92216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45826" y="92665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801093" y="92216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65906" y="92216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73183" y="4149080"/>
            <a:ext cx="5237393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095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240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                     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50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39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65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45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endParaRPr lang="en-US" altLang="zh-CN" sz="9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43" name="Picture 3" descr="C:\Users\zhangyanan\AppData\Roaming\Tencent\Users\851434558\QQ\WinTemp\RichOle\8Z3GY4T8QS8BCY~MVDR8F7P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8627" y="1103039"/>
            <a:ext cx="1656184" cy="25083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4443224" y="890500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776976" y="89050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096675" y="89498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425048" y="89946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717853" y="89050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609002" y="147133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箭头连接符 22"/>
          <p:cNvCxnSpPr/>
          <p:nvPr/>
        </p:nvCxnSpPr>
        <p:spPr>
          <a:xfrm>
            <a:off x="4184687" y="1660467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45" name="Picture 5" descr="C:\Users\zhangyanan\AppData\Roaming\Tencent\Users\851434558\QQ\WinTemp\RichOle\4$_P@0888GIRQ5PLX)L(_@C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80312" y="1103039"/>
            <a:ext cx="878516" cy="25083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7427219" y="894983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68344" y="89050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963548" y="89050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左大括号 24"/>
          <p:cNvSpPr/>
          <p:nvPr/>
        </p:nvSpPr>
        <p:spPr>
          <a:xfrm rot="16200000">
            <a:off x="1672431" y="1853850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左大括号 28"/>
          <p:cNvSpPr/>
          <p:nvPr/>
        </p:nvSpPr>
        <p:spPr>
          <a:xfrm rot="16200000">
            <a:off x="2332739" y="1985510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左大括号 29"/>
          <p:cNvSpPr/>
          <p:nvPr/>
        </p:nvSpPr>
        <p:spPr>
          <a:xfrm rot="16200000">
            <a:off x="3028226" y="1973153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左大括号 30"/>
          <p:cNvSpPr/>
          <p:nvPr/>
        </p:nvSpPr>
        <p:spPr>
          <a:xfrm rot="16200000">
            <a:off x="5069164" y="1562136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左大括号 31"/>
          <p:cNvSpPr/>
          <p:nvPr/>
        </p:nvSpPr>
        <p:spPr>
          <a:xfrm rot="16200000">
            <a:off x="5692401" y="1578176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左大括号 32"/>
          <p:cNvSpPr/>
          <p:nvPr/>
        </p:nvSpPr>
        <p:spPr>
          <a:xfrm rot="16200000">
            <a:off x="7920481" y="1730042"/>
            <a:ext cx="133793" cy="395437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4432" y="99216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K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581483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7" name="Picture 3" descr="C:\Users\zhangyanan\AppData\Roaming\Tencent\Users\851434558\QQ\WinTemp\RichOle\8QKG_M8~O~3DMI4XD9G2R7E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1206638"/>
            <a:ext cx="1660566" cy="2294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85047" y="991761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52818" y="100284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83590" y="100762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9512" y="162880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/>
          <p:cNvCxnSpPr/>
          <p:nvPr/>
        </p:nvCxnSpPr>
        <p:spPr>
          <a:xfrm>
            <a:off x="755197" y="1817930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899592" y="3718773"/>
            <a:ext cx="83498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735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WT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                 4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72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5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                       6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72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57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68" name="Picture 4" descr="C:\Users\zhangyanan\AppData\Roaming\Tencent\Users\851434558\QQ\WinTemp\RichOle\071J6C`UNX%]WE@%L5{2[Y4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4494" y="1227511"/>
            <a:ext cx="1739253" cy="2262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637689" y="1021069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944547" y="102106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19132" y="101210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83945" y="102106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93000" y="101210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269" name="Picture 5" descr="C:\Users\zhangyanan\AppData\Roaming\Tencent\Users\851434558\QQ\WinTemp\RichOle\E%M`UMIRO~07IFW)ORV~1JU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2" y="1206638"/>
            <a:ext cx="792088" cy="22734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803467" y="164224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>
            <a:off x="3379152" y="1831377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700374" y="201988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5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箭头连接符 22"/>
          <p:cNvCxnSpPr/>
          <p:nvPr/>
        </p:nvCxnSpPr>
        <p:spPr>
          <a:xfrm>
            <a:off x="3370188" y="2222466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508104" y="159713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>
          <a:xfrm>
            <a:off x="6083789" y="1786263"/>
            <a:ext cx="21640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6577176" y="100762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840688" y="100762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318412" y="1007622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大括号 28"/>
          <p:cNvSpPr/>
          <p:nvPr/>
        </p:nvSpPr>
        <p:spPr>
          <a:xfrm rot="16200000">
            <a:off x="2213437" y="1757129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左大括号 29"/>
          <p:cNvSpPr/>
          <p:nvPr/>
        </p:nvSpPr>
        <p:spPr>
          <a:xfrm rot="16200000">
            <a:off x="4264598" y="2094589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左大括号 30"/>
          <p:cNvSpPr/>
          <p:nvPr/>
        </p:nvSpPr>
        <p:spPr>
          <a:xfrm rot="16200000">
            <a:off x="4912670" y="1802874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左大括号 31"/>
          <p:cNvSpPr/>
          <p:nvPr/>
        </p:nvSpPr>
        <p:spPr>
          <a:xfrm rot="16200000">
            <a:off x="6833238" y="1740021"/>
            <a:ext cx="98271" cy="370384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4432" y="9921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79190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C:\Users\zhangyanan\AppData\Roaming\Tencent\Users\851434558\QQ\WinTemp\RichOle\~RLZG_[XD7D)WDD`VF~RO7G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1508" y="836713"/>
            <a:ext cx="1929136" cy="30963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348916" y="620688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31640" y="62958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715569" y="62958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70208" y="4077072"/>
            <a:ext cx="820891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WT(F1, internal primer)                        2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454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nal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)                   3:WT(F1, R3)                           4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454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R3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455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948264" y="1525125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/>
          <p:cNvCxnSpPr/>
          <p:nvPr/>
        </p:nvCxnSpPr>
        <p:spPr>
          <a:xfrm flipH="1">
            <a:off x="6784816" y="1721820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0" name="Picture 2" descr="C:\Users\zhangyanan\Desktop\修图\2\0420_4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836713"/>
            <a:ext cx="2353221" cy="30963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左大括号 11"/>
          <p:cNvSpPr/>
          <p:nvPr/>
        </p:nvSpPr>
        <p:spPr>
          <a:xfrm rot="16200000">
            <a:off x="1701601" y="1812201"/>
            <a:ext cx="158989" cy="730425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左大括号 12"/>
          <p:cNvSpPr/>
          <p:nvPr/>
        </p:nvSpPr>
        <p:spPr>
          <a:xfrm rot="16200000">
            <a:off x="2561180" y="1816840"/>
            <a:ext cx="157922" cy="72008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左大括号 13"/>
          <p:cNvSpPr/>
          <p:nvPr/>
        </p:nvSpPr>
        <p:spPr>
          <a:xfrm rot="16200000">
            <a:off x="5107142" y="1655816"/>
            <a:ext cx="122985" cy="543064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2271187" y="63304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750529" y="63304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812738" y="63433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198801" y="63304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168911" y="637161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79912" y="145845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箭头连接符 21"/>
          <p:cNvCxnSpPr/>
          <p:nvPr/>
        </p:nvCxnSpPr>
        <p:spPr>
          <a:xfrm flipH="1">
            <a:off x="3616464" y="1655145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矩形 22"/>
          <p:cNvSpPr/>
          <p:nvPr/>
        </p:nvSpPr>
        <p:spPr>
          <a:xfrm>
            <a:off x="4432" y="99216"/>
            <a:ext cx="5565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342733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0" name="Picture 4" descr="C:\Users\zhangyanan\Desktop\偏最小二乘\72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41" y="3946180"/>
            <a:ext cx="3719718" cy="20145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组合 6"/>
          <p:cNvGrpSpPr/>
          <p:nvPr/>
        </p:nvGrpSpPr>
        <p:grpSpPr>
          <a:xfrm>
            <a:off x="4987125" y="395936"/>
            <a:ext cx="3850271" cy="2387882"/>
            <a:chOff x="4987125" y="395936"/>
            <a:chExt cx="3850271" cy="2387882"/>
          </a:xfrm>
        </p:grpSpPr>
        <p:pic>
          <p:nvPicPr>
            <p:cNvPr id="4099" name="Picture 3" descr="C:\Users\zhangyanan\Desktop\偏最小二乘\48h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75937" y="756605"/>
              <a:ext cx="3661459" cy="20272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6" name="椭圆 65"/>
            <p:cNvSpPr/>
            <p:nvPr/>
          </p:nvSpPr>
          <p:spPr bwMode="auto">
            <a:xfrm rot="7254905">
              <a:off x="6341292" y="1942465"/>
              <a:ext cx="522466" cy="224054"/>
            </a:xfrm>
            <a:prstGeom prst="ellipse">
              <a:avLst/>
            </a:prstGeom>
            <a:noFill/>
            <a:ln w="25400" cap="flat" cmpd="sng" algn="ctr">
              <a:solidFill>
                <a:srgbClr val="33B355"/>
              </a:solidFill>
              <a:prstDash val="solid"/>
            </a:ln>
            <a:effectLst/>
          </p:spPr>
          <p:txBody>
            <a:bodyPr anchor="ctr"/>
            <a:lstStyle/>
            <a:p>
              <a:pPr marL="0" marR="0" lvl="0" indent="0" algn="ctr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987125" y="395936"/>
              <a:ext cx="8381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8 h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-36512" y="44624"/>
            <a:ext cx="3277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ig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79512" y="384919"/>
            <a:ext cx="459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 descr="C:\Users\zhangyanan\Desktop\偏最小二乘\24h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61" y="755100"/>
            <a:ext cx="3660298" cy="20541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组合 3"/>
          <p:cNvGrpSpPr/>
          <p:nvPr/>
        </p:nvGrpSpPr>
        <p:grpSpPr>
          <a:xfrm>
            <a:off x="179512" y="1068644"/>
            <a:ext cx="5329144" cy="2144332"/>
            <a:chOff x="241967" y="1236218"/>
            <a:chExt cx="5329144" cy="2144332"/>
          </a:xfrm>
        </p:grpSpPr>
        <p:sp>
          <p:nvSpPr>
            <p:cNvPr id="5" name="TextBox 4"/>
            <p:cNvSpPr txBox="1"/>
            <p:nvPr/>
          </p:nvSpPr>
          <p:spPr>
            <a:xfrm>
              <a:off x="529999" y="2948502"/>
              <a:ext cx="50411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          -10        -8        -6         -4         -2          0          2          4           6          8         10        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114175" y="3118940"/>
              <a:ext cx="1048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itchFamily="18" charset="0"/>
                  <a:cs typeface="Times New Roman" pitchFamily="18" charset="0"/>
                </a:rPr>
                <a:t>t[1] 52.1%</a:t>
              </a:r>
              <a:endParaRPr lang="zh-CN" alt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8791" y="1819563"/>
              <a:ext cx="216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99338" y="1540230"/>
              <a:ext cx="216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09168" y="1236218"/>
              <a:ext cx="2160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7608" y="2115449"/>
              <a:ext cx="381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-2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1225" y="2408732"/>
              <a:ext cx="3605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-4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0800000">
              <a:off x="241967" y="1393254"/>
              <a:ext cx="353943" cy="90717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itchFamily="18" charset="0"/>
                  <a:cs typeface="Times New Roman" pitchFamily="18" charset="0"/>
                </a:rPr>
                <a:t>t[2] 17.9%</a:t>
              </a:r>
              <a:endParaRPr lang="zh-CN" alt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3" name="椭圆 52"/>
          <p:cNvSpPr/>
          <p:nvPr/>
        </p:nvSpPr>
        <p:spPr bwMode="auto">
          <a:xfrm rot="7178250">
            <a:off x="2657583" y="2076961"/>
            <a:ext cx="340762" cy="237276"/>
          </a:xfrm>
          <a:prstGeom prst="ellipse">
            <a:avLst/>
          </a:prstGeom>
          <a:noFill/>
          <a:ln w="25400" cap="flat" cmpd="sng" algn="ctr">
            <a:solidFill>
              <a:srgbClr val="000000"/>
            </a:solidFill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</a:endParaRPr>
          </a:p>
        </p:txBody>
      </p:sp>
      <p:sp>
        <p:nvSpPr>
          <p:cNvPr id="54" name="椭圆 53"/>
          <p:cNvSpPr/>
          <p:nvPr/>
        </p:nvSpPr>
        <p:spPr bwMode="auto">
          <a:xfrm rot="10203988">
            <a:off x="2708853" y="1422785"/>
            <a:ext cx="624295" cy="237333"/>
          </a:xfrm>
          <a:prstGeom prst="ellipse">
            <a:avLst/>
          </a:prstGeom>
          <a:noFill/>
          <a:ln w="25400" cap="flat" cmpd="sng" algn="ctr">
            <a:solidFill>
              <a:srgbClr val="FF0000"/>
            </a:solidFill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</a:endParaRPr>
          </a:p>
        </p:txBody>
      </p:sp>
      <p:sp>
        <p:nvSpPr>
          <p:cNvPr id="56" name="椭圆 55"/>
          <p:cNvSpPr/>
          <p:nvPr/>
        </p:nvSpPr>
        <p:spPr bwMode="auto">
          <a:xfrm rot="3306264">
            <a:off x="2026926" y="1149183"/>
            <a:ext cx="433394" cy="687358"/>
          </a:xfrm>
          <a:prstGeom prst="ellipse">
            <a:avLst/>
          </a:prstGeom>
          <a:noFill/>
          <a:ln w="25400" cap="flat" cmpd="sng" algn="ctr">
            <a:solidFill>
              <a:srgbClr val="7030A0"/>
            </a:solidFill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46713" y="773725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Times New Roman" pitchFamily="18" charset="0"/>
                <a:cs typeface="Times New Roman" pitchFamily="18" charset="0"/>
              </a:rPr>
              <a:t>6</a:t>
            </a:r>
            <a:endParaRPr lang="zh-CN" alt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05153" y="2542609"/>
            <a:ext cx="369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Times New Roman" pitchFamily="18" charset="0"/>
                <a:cs typeface="Times New Roman" pitchFamily="18" charset="0"/>
              </a:rPr>
              <a:t>-6</a:t>
            </a:r>
            <a:endParaRPr lang="zh-CN" alt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椭圆 63"/>
          <p:cNvSpPr/>
          <p:nvPr/>
        </p:nvSpPr>
        <p:spPr bwMode="auto">
          <a:xfrm rot="11465186">
            <a:off x="1515785" y="1709103"/>
            <a:ext cx="386021" cy="265608"/>
          </a:xfrm>
          <a:prstGeom prst="ellipse">
            <a:avLst/>
          </a:prstGeom>
          <a:noFill/>
          <a:ln w="25400" cap="flat" cmpd="sng" algn="ctr">
            <a:solidFill>
              <a:srgbClr val="33B355"/>
            </a:solidFill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48713" y="391251"/>
            <a:ext cx="838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5377529" y="4262807"/>
            <a:ext cx="1924423" cy="1383679"/>
            <a:chOff x="6876256" y="3629497"/>
            <a:chExt cx="1924423" cy="1383679"/>
          </a:xfrm>
        </p:grpSpPr>
        <p:pic>
          <p:nvPicPr>
            <p:cNvPr id="67" name="Picture 7" descr="C:\Users\zhangyanan\Desktop\hong.PN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76256" y="3879106"/>
              <a:ext cx="501053" cy="4817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8" name="Picture 4" descr="C:\Users\zhangyanan\Desktop\hei.PN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96511" y="3629497"/>
              <a:ext cx="505995" cy="3748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9" name="Picture 9" descr="C:\Users\zhangyanan\Desktop\zi.PN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34123" y="4627855"/>
              <a:ext cx="385321" cy="3853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0" name="TextBox 69"/>
            <p:cNvSpPr txBox="1"/>
            <p:nvPr/>
          </p:nvSpPr>
          <p:spPr>
            <a:xfrm>
              <a:off x="7236382" y="3629867"/>
              <a:ext cx="12514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-C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7258490" y="4315699"/>
              <a:ext cx="12514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-E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225759" y="3944622"/>
              <a:ext cx="15749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600" i="1" dirty="0" smtClean="0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en-US" altLang="zh-CN" sz="1600" i="1" dirty="0" smtClean="0">
                  <a:latin typeface="Times New Roman" pitchFamily="18" charset="0"/>
                  <a:cs typeface="Times New Roman" pitchFamily="18" charset="0"/>
                </a:rPr>
                <a:t>slr0982-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C 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213840" y="4654253"/>
              <a:ext cx="15749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600" i="1" dirty="0" smtClean="0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en-US" altLang="zh-CN" sz="1600" i="1" dirty="0" smtClean="0">
                  <a:latin typeface="Times New Roman" pitchFamily="18" charset="0"/>
                  <a:cs typeface="Times New Roman" pitchFamily="18" charset="0"/>
                </a:rPr>
                <a:t>slr0982-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74" name="Picture 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74494" y="4320151"/>
              <a:ext cx="367686" cy="329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0" name="组合 19"/>
          <p:cNvGrpSpPr/>
          <p:nvPr/>
        </p:nvGrpSpPr>
        <p:grpSpPr>
          <a:xfrm>
            <a:off x="4716016" y="384919"/>
            <a:ext cx="5349800" cy="2801635"/>
            <a:chOff x="1343156" y="3119889"/>
            <a:chExt cx="5349800" cy="2801635"/>
          </a:xfrm>
        </p:grpSpPr>
        <p:grpSp>
          <p:nvGrpSpPr>
            <p:cNvPr id="16" name="组合 15"/>
            <p:cNvGrpSpPr/>
            <p:nvPr/>
          </p:nvGrpSpPr>
          <p:grpSpPr>
            <a:xfrm>
              <a:off x="1421260" y="3452982"/>
              <a:ext cx="5271696" cy="2468542"/>
              <a:chOff x="1421260" y="3452982"/>
              <a:chExt cx="5271696" cy="2468542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1651844" y="5491078"/>
                <a:ext cx="504111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    -10         -8          -6          -4           -2          0            2           4            6           8           10        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632956" y="5020930"/>
                <a:ext cx="3605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-4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624843" y="4704692"/>
                <a:ext cx="3663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-2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655385" y="4409438"/>
                <a:ext cx="216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653158" y="4068865"/>
                <a:ext cx="216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652790" y="3752814"/>
                <a:ext cx="216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4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655385" y="3452982"/>
                <a:ext cx="216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6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615153" y="5334379"/>
                <a:ext cx="3693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-6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0800000">
                <a:off x="1421260" y="4030203"/>
                <a:ext cx="353943" cy="83762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100" b="1" dirty="0" smtClean="0">
                    <a:latin typeface="Times New Roman" pitchFamily="18" charset="0"/>
                    <a:cs typeface="Times New Roman" pitchFamily="18" charset="0"/>
                  </a:rPr>
                  <a:t>t[2] 16.2%</a:t>
                </a:r>
                <a:endParaRPr lang="zh-CN" altLang="en-US" sz="11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287372" y="5659914"/>
                <a:ext cx="8640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 smtClean="0">
                    <a:latin typeface="Times New Roman" pitchFamily="18" charset="0"/>
                    <a:cs typeface="Times New Roman" pitchFamily="18" charset="0"/>
                  </a:rPr>
                  <a:t>t[1] 42.6%</a:t>
                </a:r>
                <a:endParaRPr lang="zh-CN" altLang="en-US" sz="11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52" name="TextBox 51"/>
            <p:cNvSpPr txBox="1"/>
            <p:nvPr/>
          </p:nvSpPr>
          <p:spPr>
            <a:xfrm>
              <a:off x="1343156" y="3119889"/>
              <a:ext cx="45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zh-CN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椭圆 57"/>
            <p:cNvSpPr/>
            <p:nvPr/>
          </p:nvSpPr>
          <p:spPr bwMode="auto">
            <a:xfrm rot="7562052">
              <a:off x="3910953" y="4547677"/>
              <a:ext cx="731011" cy="39364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  <a:ea typeface="宋体" charset="-122"/>
              </a:endParaRPr>
            </a:p>
          </p:txBody>
        </p:sp>
        <p:sp>
          <p:nvSpPr>
            <p:cNvPr id="59" name="椭圆 58"/>
            <p:cNvSpPr/>
            <p:nvPr/>
          </p:nvSpPr>
          <p:spPr bwMode="auto">
            <a:xfrm rot="8581508">
              <a:off x="3807190" y="4109074"/>
              <a:ext cx="414105" cy="190866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  <a:ea typeface="宋体" charset="-122"/>
              </a:endParaRPr>
            </a:p>
          </p:txBody>
        </p:sp>
        <p:sp>
          <p:nvSpPr>
            <p:cNvPr id="61" name="椭圆 60"/>
            <p:cNvSpPr/>
            <p:nvPr/>
          </p:nvSpPr>
          <p:spPr bwMode="auto">
            <a:xfrm rot="7207173">
              <a:off x="2747606" y="4094805"/>
              <a:ext cx="598467" cy="428619"/>
            </a:xfrm>
            <a:prstGeom prst="ellipse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  <a:ea typeface="宋体" charset="-122"/>
              </a:endParaRPr>
            </a:p>
          </p:txBody>
        </p:sp>
      </p:grpSp>
      <p:sp>
        <p:nvSpPr>
          <p:cNvPr id="76" name="TextBox 75"/>
          <p:cNvSpPr txBox="1"/>
          <p:nvPr/>
        </p:nvSpPr>
        <p:spPr>
          <a:xfrm rot="10800000">
            <a:off x="179513" y="4580922"/>
            <a:ext cx="353943" cy="72028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100" b="1" dirty="0" smtClean="0">
                <a:latin typeface="Times New Roman" pitchFamily="18" charset="0"/>
                <a:cs typeface="Times New Roman" pitchFamily="18" charset="0"/>
              </a:rPr>
              <a:t>t[2] 18.1%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91343" y="3625279"/>
            <a:ext cx="608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9" name="组合 78"/>
          <p:cNvGrpSpPr/>
          <p:nvPr/>
        </p:nvGrpSpPr>
        <p:grpSpPr>
          <a:xfrm>
            <a:off x="238819" y="3977697"/>
            <a:ext cx="4261173" cy="2331623"/>
            <a:chOff x="1045511" y="1557844"/>
            <a:chExt cx="6633760" cy="3231091"/>
          </a:xfrm>
        </p:grpSpPr>
        <p:sp>
          <p:nvSpPr>
            <p:cNvPr id="91" name="TextBox 90"/>
            <p:cNvSpPr txBox="1"/>
            <p:nvPr/>
          </p:nvSpPr>
          <p:spPr>
            <a:xfrm>
              <a:off x="1045511" y="4252500"/>
              <a:ext cx="6633760" cy="2985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Times New Roman" pitchFamily="18" charset="0"/>
                  <a:cs typeface="Times New Roman" pitchFamily="18" charset="0"/>
                </a:rPr>
                <a:t>           -10         -8           -6          -4          -2            0            2            4            6            8           10        </a:t>
              </a:r>
              <a:endParaRPr lang="zh-CN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92" name="组合 91"/>
            <p:cNvGrpSpPr/>
            <p:nvPr/>
          </p:nvGrpSpPr>
          <p:grpSpPr>
            <a:xfrm>
              <a:off x="1279180" y="1557844"/>
              <a:ext cx="750734" cy="2674690"/>
              <a:chOff x="1406019" y="3711725"/>
              <a:chExt cx="750734" cy="2674690"/>
            </a:xfrm>
          </p:grpSpPr>
          <p:sp>
            <p:nvSpPr>
              <p:cNvPr id="97" name="TextBox 96"/>
              <p:cNvSpPr txBox="1"/>
              <p:nvPr/>
            </p:nvSpPr>
            <p:spPr>
              <a:xfrm>
                <a:off x="1406019" y="5692541"/>
                <a:ext cx="626866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-4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1417158" y="5296742"/>
                <a:ext cx="637983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-2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1490945" y="4889048"/>
                <a:ext cx="216024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1508655" y="4508380"/>
                <a:ext cx="216024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1499227" y="4099017"/>
                <a:ext cx="238090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4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1508655" y="3711725"/>
                <a:ext cx="216024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6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418251" y="6087859"/>
                <a:ext cx="738502" cy="29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-6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93" name="TextBox 92"/>
            <p:cNvSpPr txBox="1"/>
            <p:nvPr/>
          </p:nvSpPr>
          <p:spPr>
            <a:xfrm>
              <a:off x="3867821" y="4426404"/>
              <a:ext cx="1625601" cy="362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Times New Roman" pitchFamily="18" charset="0"/>
                  <a:cs typeface="Times New Roman" pitchFamily="18" charset="0"/>
                </a:rPr>
                <a:t>t[1] 42.0% </a:t>
              </a:r>
              <a:endParaRPr lang="zh-CN" altLang="en-US" sz="11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4" name="椭圆 93"/>
            <p:cNvSpPr/>
            <p:nvPr/>
          </p:nvSpPr>
          <p:spPr bwMode="auto">
            <a:xfrm rot="1862702">
              <a:off x="5104136" y="2316348"/>
              <a:ext cx="625980" cy="30468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  <a:ea typeface="宋体" charset="-122"/>
              </a:endParaRPr>
            </a:p>
          </p:txBody>
        </p:sp>
        <p:sp>
          <p:nvSpPr>
            <p:cNvPr id="95" name="椭圆 94"/>
            <p:cNvSpPr/>
            <p:nvPr/>
          </p:nvSpPr>
          <p:spPr bwMode="auto">
            <a:xfrm rot="1627827">
              <a:off x="4300489" y="3285574"/>
              <a:ext cx="1807202" cy="32670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  <a:ea typeface="宋体" charset="-122"/>
              </a:endParaRPr>
            </a:p>
          </p:txBody>
        </p:sp>
        <p:sp>
          <p:nvSpPr>
            <p:cNvPr id="96" name="椭圆 95"/>
            <p:cNvSpPr/>
            <p:nvPr/>
          </p:nvSpPr>
          <p:spPr bwMode="auto">
            <a:xfrm rot="9978521">
              <a:off x="3127054" y="2824080"/>
              <a:ext cx="895587" cy="433592"/>
            </a:xfrm>
            <a:prstGeom prst="ellipse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  <a:ea typeface="宋体" charset="-122"/>
              </a:endParaRPr>
            </a:p>
          </p:txBody>
        </p:sp>
      </p:grpSp>
      <p:sp>
        <p:nvSpPr>
          <p:cNvPr id="80" name="椭圆 79"/>
          <p:cNvSpPr/>
          <p:nvPr/>
        </p:nvSpPr>
        <p:spPr bwMode="auto">
          <a:xfrm rot="6994456">
            <a:off x="1953704" y="4650171"/>
            <a:ext cx="242135" cy="252486"/>
          </a:xfrm>
          <a:prstGeom prst="ellipse">
            <a:avLst/>
          </a:prstGeom>
          <a:noFill/>
          <a:ln w="25400" cap="flat" cmpd="sng" algn="ctr">
            <a:solidFill>
              <a:srgbClr val="33B355"/>
            </a:solidFill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50621" y="3642644"/>
            <a:ext cx="7318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h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528877" y="730796"/>
            <a:ext cx="14497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zh-CN" sz="10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61.9%</a:t>
            </a:r>
          </a:p>
          <a:p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0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.8%</a:t>
            </a:r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8074992" y="748670"/>
            <a:ext cx="14497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zh-CN" sz="10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57.1%</a:t>
            </a:r>
          </a:p>
          <a:p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0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.2%</a:t>
            </a:r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542680" y="3942422"/>
            <a:ext cx="14497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zh-CN" sz="10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58.6%</a:t>
            </a:r>
          </a:p>
          <a:p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0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.2%</a:t>
            </a:r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7446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 descr="C:\Users\zhangyanan\AppData\Roaming\Tencent\Users\851434558\QQ\WinTemp\RichOle\CW~CWNFSGD6YGLVM1N(J]BT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9749" y="1003867"/>
            <a:ext cx="5514975" cy="4714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831986" y="1202700"/>
            <a:ext cx="6370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1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0.3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591150" y="1195710"/>
            <a:ext cx="6370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83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8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609488" y="1959223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88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(2e-04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19013" y="2708920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85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(4e-04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408275" y="2002656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45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(0.1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408275" y="2790453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48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(0.1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537480" y="3520058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-0.036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(0.9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317217" y="3543399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-0.74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(0.006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622823" y="4355812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69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(0.01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408275" y="4345012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36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(0.3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665884" y="5147900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2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(0.5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398750" y="5157192"/>
            <a:ext cx="81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0.29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(0.4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96" name="Picture 4" descr="C:\Users\zhangyanan\AppData\Roaming\Tencent\Users\851434558\QQ\WinTemp\RichOle\P`(DC2{IWZHT15VSQN9G)HS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4866" y="994336"/>
            <a:ext cx="358723" cy="4738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296232" y="1196752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yello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24168" y="1988840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row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68768" y="2796147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re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848" y="3565926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turquois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81832" y="4358014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lu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39664" y="5120578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gree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131840" y="611396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ule-trait relationship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Picture 6" descr="C:\Users\zhangyanan\AppData\Roaming\Tencent\Users\851434558\QQ\WinTemp\RichOle\R2Q[DQE~)3`DCI_O1R}C}O9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2098" y="1410028"/>
            <a:ext cx="293979" cy="3942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7836172" y="1312760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776864" y="2248864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823472" y="3210368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726064" y="4142558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769944" y="5087170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9111268">
            <a:off x="2416455" y="5629531"/>
            <a:ext cx="1512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ano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9001555">
            <a:off x="5275760" y="5823486"/>
            <a:ext cx="1039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982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0" y="0"/>
            <a:ext cx="18722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(A)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79634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组合 23"/>
          <p:cNvGrpSpPr/>
          <p:nvPr/>
        </p:nvGrpSpPr>
        <p:grpSpPr>
          <a:xfrm>
            <a:off x="1403648" y="1162844"/>
            <a:ext cx="6048672" cy="4570412"/>
            <a:chOff x="1950368" y="1162844"/>
            <a:chExt cx="5175820" cy="3904763"/>
          </a:xfrm>
        </p:grpSpPr>
        <p:pic>
          <p:nvPicPr>
            <p:cNvPr id="9221" name="Picture 5" descr="C:\Users\zhangyanan\AppData\Roaming\Tencent\Users\851434558\QQ\WinTemp\RichOle\NA@O]S@8YZWUC08BOI6]RNU.pn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9860" y="1171882"/>
              <a:ext cx="4552950" cy="38957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275856" y="1167467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0.65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(0.02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508104" y="1162844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0.32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(0.3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508104" y="2636912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0.32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(0.3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64671" y="1671191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-0.32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3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508104" y="2132856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0.46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(0.1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94744" y="1643092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-0.73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(0.007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203848" y="2124363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-0.26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4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213794" y="2656988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0.25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4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13373" y="3140968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0.26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4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194323" y="3688457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-0.37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2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175273" y="4139555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-0.4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2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122315" y="4581128"/>
              <a:ext cx="15081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-0.011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(1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17629" y="3140968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0.7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(0.01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455146" y="3615407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-0.45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0.1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388724" y="4149080"/>
              <a:ext cx="17374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-0.88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2e-04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378946" y="4585320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-0.13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(0.7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220" name="Picture 4" descr="C:\Users\zhangyanan\AppData\Roaming\Tencent\Users\851434558\QQ\WinTemp\RichOle\E)8TQHI5Q$54D@IR66Q$]`7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0368" y="1170791"/>
              <a:ext cx="314325" cy="38957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30" name="Picture 6" descr="C:\Users\zhangyanan\AppData\Roaming\Tencent\Users\851434558\QQ\WinTemp\RichOle\R2Q[DQE~)3`DCI_O1R}C}O9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2098" y="1410028"/>
            <a:ext cx="293979" cy="3942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7836172" y="1312760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776864" y="2248864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823472" y="3210368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726064" y="4142558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769944" y="5087170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03848" y="755412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ule-trait relationship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9111268">
            <a:off x="2488463" y="5709073"/>
            <a:ext cx="1512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ano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9001555">
            <a:off x="5432476" y="5823486"/>
            <a:ext cx="1039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982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2504" y="1268760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turquois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41942" y="1840910"/>
            <a:ext cx="1224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lack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43342" y="2420888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lu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85878" y="2991142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row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52517" y="3582271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yello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05392" y="4158335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gree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29377" y="4725144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re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40299" y="5305802"/>
            <a:ext cx="10298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grey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23"/>
          <p:cNvSpPr txBox="1"/>
          <p:nvPr/>
        </p:nvSpPr>
        <p:spPr>
          <a:xfrm>
            <a:off x="0" y="23788"/>
            <a:ext cx="18722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(B)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034791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364928" y="1052736"/>
            <a:ext cx="6046341" cy="4743450"/>
            <a:chOff x="1971452" y="1052736"/>
            <a:chExt cx="6046341" cy="4743450"/>
          </a:xfrm>
        </p:grpSpPr>
        <p:pic>
          <p:nvPicPr>
            <p:cNvPr id="7170" name="Picture 2" descr="C:\Users\zhangyanan\AppData\Roaming\Tencent\Users\851434558\QQ\WinTemp\RichOle\CQG%FA7Y2A0M8X26M2D5S8H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3768" y="1065436"/>
              <a:ext cx="5534025" cy="46958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71" name="Picture 3" descr="C:\Users\zhangyanan\AppData\Roaming\Tencent\Users\851434558\QQ\WinTemp\RichOle\$K2E5VM9NGL`_3QFUCK}75C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1452" y="1052736"/>
              <a:ext cx="381000" cy="47434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6" name="TextBox 5"/>
          <p:cNvSpPr txBox="1"/>
          <p:nvPr/>
        </p:nvSpPr>
        <p:spPr>
          <a:xfrm>
            <a:off x="2949104" y="1196751"/>
            <a:ext cx="9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6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0.2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44376" y="1815207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98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9e-09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830088" y="2486521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66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02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40183" y="318335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26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0.4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830088" y="390343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061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(0.9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35420" y="4575894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28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0.4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810396" y="5207238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0.044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(0.9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904148" y="1196752"/>
            <a:ext cx="9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4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0.7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821650" y="185621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51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09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827132" y="2478777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67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02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796136" y="318335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076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(0.8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858128" y="3918937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19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0.6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920120" y="4586610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4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2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920120" y="5199583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0.4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2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47032" y="1196752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row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12428" y="1840910"/>
            <a:ext cx="1224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lack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89404" y="2564904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re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05242" y="3259584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blu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0756" y="3929142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turquois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54592" y="4602614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gree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3528" y="5284594"/>
            <a:ext cx="1728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 yellow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Picture 6" descr="C:\Users\zhangyanan\AppData\Roaming\Tencent\Users\851434558\QQ\WinTemp\RichOle\R2Q[DQE~)3`DCI_O1R}C}O9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6806" y="1429528"/>
            <a:ext cx="293979" cy="3942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7920880" y="1332260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861572" y="2268364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908180" y="3229868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810772" y="4162058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854652" y="5106670"/>
            <a:ext cx="539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131840" y="620688"/>
            <a:ext cx="3384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ule-trait relationship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9111268">
            <a:off x="2416455" y="5773547"/>
            <a:ext cx="1512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ano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9001555">
            <a:off x="5491490" y="5849758"/>
            <a:ext cx="1039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982</a:t>
            </a:r>
            <a:endParaRPr lang="zh-CN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23"/>
          <p:cNvSpPr txBox="1"/>
          <p:nvPr/>
        </p:nvSpPr>
        <p:spPr>
          <a:xfrm>
            <a:off x="-36512" y="116632"/>
            <a:ext cx="18722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(C)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648468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右大括号 1"/>
          <p:cNvSpPr/>
          <p:nvPr/>
        </p:nvSpPr>
        <p:spPr>
          <a:xfrm>
            <a:off x="7236296" y="4869161"/>
            <a:ext cx="193821" cy="1728191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1" name="组合 20"/>
          <p:cNvGrpSpPr/>
          <p:nvPr/>
        </p:nvGrpSpPr>
        <p:grpSpPr>
          <a:xfrm>
            <a:off x="605" y="28994"/>
            <a:ext cx="8202332" cy="6829006"/>
            <a:chOff x="-29839" y="28994"/>
            <a:chExt cx="8673727" cy="6836894"/>
          </a:xfrm>
        </p:grpSpPr>
        <p:grpSp>
          <p:nvGrpSpPr>
            <p:cNvPr id="13" name="组合 12"/>
            <p:cNvGrpSpPr/>
            <p:nvPr/>
          </p:nvGrpSpPr>
          <p:grpSpPr>
            <a:xfrm>
              <a:off x="-29839" y="28994"/>
              <a:ext cx="8673727" cy="6836894"/>
              <a:chOff x="-69279" y="1"/>
              <a:chExt cx="8673727" cy="6836894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-69279" y="1"/>
                <a:ext cx="8673727" cy="6836894"/>
                <a:chOff x="-69279" y="1"/>
                <a:chExt cx="8673727" cy="6836894"/>
              </a:xfrm>
            </p:grpSpPr>
            <p:pic>
              <p:nvPicPr>
                <p:cNvPr id="1027" name="Picture 3" descr="C:\Users\zhangyanan\Desktop\24h-WGCNA.PNG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69279" y="1"/>
                  <a:ext cx="6700880" cy="683689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8" name="TextBox 7"/>
                <p:cNvSpPr txBox="1"/>
                <p:nvPr/>
              </p:nvSpPr>
              <p:spPr>
                <a:xfrm>
                  <a:off x="6300192" y="1756986"/>
                  <a:ext cx="2304256" cy="2246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prylic</a:t>
                  </a:r>
                  <a:r>
                    <a:rPr lang="en-US" altLang="zh-CN" sz="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zh-CN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id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ycine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hosphoric acid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ycolic acid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ycerol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agatose</a:t>
                  </a:r>
                  <a:endParaRPr lang="en-US" altLang="zh-CN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-threonine</a:t>
                  </a:r>
                  <a:endParaRPr lang="en-US" altLang="zh-CN" sz="600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solidFill>
                        <a:srgbClr val="0000FF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-</a:t>
                  </a:r>
                  <a:r>
                    <a:rPr lang="en-US" altLang="zh-CN" sz="600" dirty="0" err="1" smtClean="0">
                      <a:solidFill>
                        <a:srgbClr val="0000FF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lose</a:t>
                  </a:r>
                  <a:endParaRPr lang="en-US" altLang="zh-CN" sz="6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denosine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pric</a:t>
                  </a:r>
                  <a:r>
                    <a:rPr lang="en-US" altLang="zh-CN" sz="600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zh-CN" sz="6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id</a:t>
                  </a:r>
                  <a:endParaRPr lang="en-US" altLang="zh-CN" sz="600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onic</a:t>
                  </a:r>
                  <a:r>
                    <a:rPr lang="en-US" altLang="zh-CN" sz="600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zh-CN" sz="6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id 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-amino-1-phenylethanol</a:t>
                  </a:r>
                  <a:endParaRPr lang="en-US" altLang="zh-CN" sz="600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-hydroxybutyric </a:t>
                  </a:r>
                  <a:r>
                    <a:rPr lang="en-US" altLang="zh-CN" sz="600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id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rea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-hydroxy-L-tryptophan</a:t>
                  </a:r>
                  <a:endParaRPr lang="en-US" altLang="zh-CN" sz="6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uconic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cid lactone</a:t>
                  </a: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-glucose</a:t>
                  </a:r>
                  <a:endParaRPr lang="en-US" altLang="zh-CN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alose</a:t>
                  </a:r>
                  <a:endParaRPr lang="en-US" altLang="zh-CN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ioctyl</a:t>
                  </a:r>
                  <a:r>
                    <a:rPr lang="en-US" altLang="zh-CN" sz="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phthalate</a:t>
                  </a:r>
                  <a:endParaRPr lang="en-US" altLang="zh-CN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ethyl-beta-D-</a:t>
                  </a:r>
                  <a:r>
                    <a:rPr lang="en-US" altLang="zh-CN" sz="6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lactopyranoside</a:t>
                  </a:r>
                  <a:endParaRPr lang="en-US" altLang="zh-CN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>
                    <a:lnSpc>
                      <a:spcPts val="750"/>
                    </a:lnSpc>
                  </a:pPr>
                  <a:r>
                    <a:rPr lang="en-US" altLang="zh-CN" sz="600" dirty="0" smtClean="0">
                      <a:solidFill>
                        <a:srgbClr val="0000FF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L-isoleucine</a:t>
                  </a:r>
                  <a:endParaRPr lang="en-US" altLang="zh-CN" sz="6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" name="TextBox 9"/>
              <p:cNvSpPr txBox="1"/>
              <p:nvPr/>
            </p:nvSpPr>
            <p:spPr>
              <a:xfrm>
                <a:off x="6300192" y="3861048"/>
                <a:ext cx="2232248" cy="6052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50"/>
                  </a:lnSpc>
                </a:pP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leic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ptadecanoic</a:t>
                </a: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noleic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uric</a:t>
                </a: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ristic</a:t>
                </a: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d</a:t>
                </a:r>
                <a:endParaRPr lang="en-US" altLang="zh-CN" sz="7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300192" y="4365102"/>
                <a:ext cx="1656184" cy="11182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lmitic</a:t>
                </a: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earic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-hydroxypyridine</a:t>
                </a:r>
                <a:endParaRPr lang="en-US" altLang="zh-CN" sz="700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lmitoleic</a:t>
                </a:r>
                <a:r>
                  <a:rPr lang="en-US" altLang="zh-CN" sz="700" dirty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-(+)-</a:t>
                </a:r>
                <a:r>
                  <a:rPr lang="en-US" altLang="zh-CN" sz="700" dirty="0" err="1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lactos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L-3,4-dihydroxyphenyl-glycol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ccinic acid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-glucose-6-phosphat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serin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</a:t>
                </a:r>
                <a:r>
                  <a:rPr lang="en-US" altLang="zh-CN" sz="700" dirty="0" err="1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leucin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300192" y="5345921"/>
                <a:ext cx="1296144" cy="13234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-hydroxypyridin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nzene-1,2,4-triol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ytol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(+)-lactic </a:t>
                </a:r>
                <a:r>
                  <a:rPr lang="en-US" altLang="zh-CN" sz="7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rmidin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nzoic 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err="1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rphin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cros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ycerol-1-phosphat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</a:t>
                </a:r>
                <a:r>
                  <a:rPr lang="en-US" altLang="zh-CN" sz="700" dirty="0" err="1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yroglutamic</a:t>
                </a: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d</a:t>
                </a: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-(+)-</a:t>
                </a:r>
                <a:r>
                  <a:rPr lang="en-US" altLang="zh-CN" sz="700" dirty="0" err="1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ehalose</a:t>
                </a:r>
                <a:endParaRPr lang="en-US" altLang="zh-CN" sz="7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750"/>
                  </a:lnSpc>
                </a:pPr>
                <a:r>
                  <a:rPr lang="en-US" altLang="zh-CN" sz="7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glutamic </a:t>
                </a:r>
                <a:r>
                  <a:rPr lang="en-US" altLang="zh-CN" sz="7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d</a:t>
                </a:r>
              </a:p>
            </p:txBody>
          </p:sp>
        </p:grpSp>
        <p:sp>
          <p:nvSpPr>
            <p:cNvPr id="3" name="右大括号 2"/>
            <p:cNvSpPr/>
            <p:nvPr/>
          </p:nvSpPr>
          <p:spPr>
            <a:xfrm>
              <a:off x="7668344" y="2636912"/>
              <a:ext cx="96911" cy="504056"/>
            </a:xfrm>
            <a:prstGeom prst="rightBrace">
              <a:avLst>
                <a:gd name="adj1" fmla="val 27990"/>
                <a:gd name="adj2" fmla="val 46977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右大括号 3"/>
            <p:cNvSpPr/>
            <p:nvPr/>
          </p:nvSpPr>
          <p:spPr>
            <a:xfrm>
              <a:off x="7668344" y="3172211"/>
              <a:ext cx="132915" cy="275229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右大括号 5"/>
            <p:cNvSpPr/>
            <p:nvPr/>
          </p:nvSpPr>
          <p:spPr>
            <a:xfrm>
              <a:off x="7649206" y="3933056"/>
              <a:ext cx="165482" cy="907111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7308304" y="2708920"/>
            <a:ext cx="1080728" cy="3208958"/>
            <a:chOff x="7668344" y="2708920"/>
            <a:chExt cx="1080728" cy="3208958"/>
          </a:xfrm>
        </p:grpSpPr>
        <p:sp>
          <p:nvSpPr>
            <p:cNvPr id="15" name="文本框 18"/>
            <p:cNvSpPr txBox="1">
              <a:spLocks noChangeArrowheads="1"/>
            </p:cNvSpPr>
            <p:nvPr/>
          </p:nvSpPr>
          <p:spPr bwMode="auto">
            <a:xfrm>
              <a:off x="7740352" y="5548633"/>
              <a:ext cx="1008720" cy="369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8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kumimoji="0" lang="en-US" altLang="zh-CN" sz="1800" dirty="0" smtClean="0">
                  <a:solidFill>
                    <a:srgbClr val="00FFFF"/>
                  </a:solidFill>
                  <a:latin typeface="Times New Roman" pitchFamily="18" charset="0"/>
                  <a:cs typeface="Times New Roman" pitchFamily="18" charset="0"/>
                </a:rPr>
                <a:t>M4</a:t>
              </a:r>
              <a:endParaRPr kumimoji="0" lang="zh-CN" altLang="en-US" sz="1800" dirty="0" smtClean="0">
                <a:solidFill>
                  <a:srgbClr val="00FF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文本框 18"/>
            <p:cNvSpPr txBox="1">
              <a:spLocks noChangeArrowheads="1"/>
            </p:cNvSpPr>
            <p:nvPr/>
          </p:nvSpPr>
          <p:spPr bwMode="auto">
            <a:xfrm>
              <a:off x="7668344" y="2708920"/>
              <a:ext cx="1008720" cy="369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800" dirty="0" smtClean="0">
                  <a:solidFill>
                    <a:srgbClr val="C00000"/>
                  </a:solidFill>
                  <a:latin typeface="Times New Roman" pitchFamily="18" charset="0"/>
                  <a:cs typeface="Times New Roman" pitchFamily="18" charset="0"/>
                </a:rPr>
                <a:t>  M1</a:t>
              </a:r>
              <a:endParaRPr kumimoji="0" lang="zh-CN" altLang="en-US" sz="1800" dirty="0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文本框 18"/>
            <p:cNvSpPr txBox="1">
              <a:spLocks noChangeArrowheads="1"/>
            </p:cNvSpPr>
            <p:nvPr/>
          </p:nvSpPr>
          <p:spPr bwMode="auto">
            <a:xfrm>
              <a:off x="7689315" y="3131763"/>
              <a:ext cx="1008720" cy="369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800" dirty="0" smtClean="0">
                  <a:solidFill>
                    <a:srgbClr val="C00000"/>
                  </a:solidFill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kumimoji="0" lang="en-US" altLang="zh-CN" sz="18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M2</a:t>
              </a:r>
              <a:endParaRPr kumimoji="0" lang="zh-CN" altLang="en-US" sz="18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文本框 18"/>
            <p:cNvSpPr txBox="1">
              <a:spLocks noChangeArrowheads="1"/>
            </p:cNvSpPr>
            <p:nvPr/>
          </p:nvSpPr>
          <p:spPr bwMode="auto">
            <a:xfrm>
              <a:off x="7668344" y="4211883"/>
              <a:ext cx="1008720" cy="369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8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kumimoji="0" lang="en-US" altLang="zh-CN" sz="18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M3</a:t>
              </a:r>
              <a:endParaRPr kumimoji="0" lang="zh-CN" altLang="en-US" sz="1800" dirty="0" smtClean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-27296" y="0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S4(A)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5730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876478" y="4161854"/>
            <a:ext cx="42579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WT(F1, R3)                     2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slr0982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4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064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)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00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3131840" y="469188"/>
            <a:ext cx="5780073" cy="3527050"/>
            <a:chOff x="477010" y="261990"/>
            <a:chExt cx="5780073" cy="3527050"/>
          </a:xfrm>
        </p:grpSpPr>
        <p:pic>
          <p:nvPicPr>
            <p:cNvPr id="1026" name="Picture 2" descr="C:\Users\zhangyanan\Desktop\修图\2\0064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7010" y="476672"/>
              <a:ext cx="2160240" cy="3312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2220442" y="269474"/>
              <a:ext cx="2727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51006" y="271681"/>
              <a:ext cx="4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198090" y="261990"/>
              <a:ext cx="4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2" descr="C:\Users\zhangyanan\Desktop\修图\2\1200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73354" y="491662"/>
              <a:ext cx="1449071" cy="32973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4596707" y="290628"/>
              <a:ext cx="2727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649305" y="276980"/>
              <a:ext cx="4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71086" y="285329"/>
              <a:ext cx="4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248971" y="950748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k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直接箭头连接符 10"/>
            <p:cNvCxnSpPr/>
            <p:nvPr/>
          </p:nvCxnSpPr>
          <p:spPr>
            <a:xfrm flipH="1">
              <a:off x="5085523" y="1147443"/>
              <a:ext cx="216024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2818630" y="1229488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k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 flipH="1">
              <a:off x="2655182" y="1426183"/>
              <a:ext cx="216024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左大括号 15"/>
            <p:cNvSpPr/>
            <p:nvPr/>
          </p:nvSpPr>
          <p:spPr>
            <a:xfrm rot="16200000">
              <a:off x="968492" y="1371275"/>
              <a:ext cx="184974" cy="591873"/>
            </a:xfrm>
            <a:prstGeom prst="leftBrac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左大括号 16"/>
            <p:cNvSpPr/>
            <p:nvPr/>
          </p:nvSpPr>
          <p:spPr>
            <a:xfrm rot="16200000">
              <a:off x="3992009" y="1054332"/>
              <a:ext cx="184974" cy="591873"/>
            </a:xfrm>
            <a:prstGeom prst="leftBrac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107504" y="430987"/>
            <a:ext cx="2448272" cy="3562286"/>
            <a:chOff x="5868144" y="278064"/>
            <a:chExt cx="2448272" cy="3562286"/>
          </a:xfrm>
        </p:grpSpPr>
        <p:pic>
          <p:nvPicPr>
            <p:cNvPr id="18" name="Picture 3" descr="C:\Users\zhangyanan\Documents\Tencent Files\851434558\Image\Image1\WWE48N9GVSPN$L)(_E11OA8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32240" y="496565"/>
              <a:ext cx="1512168" cy="33437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5868144" y="1138392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k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直接箭头连接符 19"/>
            <p:cNvCxnSpPr/>
            <p:nvPr/>
          </p:nvCxnSpPr>
          <p:spPr>
            <a:xfrm>
              <a:off x="6410755" y="1348367"/>
              <a:ext cx="288032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6805840" y="278064"/>
              <a:ext cx="2727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297256" y="287944"/>
              <a:ext cx="4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873320" y="290216"/>
              <a:ext cx="4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左大括号 23"/>
            <p:cNvSpPr/>
            <p:nvPr/>
          </p:nvSpPr>
          <p:spPr>
            <a:xfrm rot="16200000">
              <a:off x="7626312" y="1220380"/>
              <a:ext cx="184974" cy="591873"/>
            </a:xfrm>
            <a:prstGeom prst="leftBrac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6" name="矩形 25"/>
          <p:cNvSpPr/>
          <p:nvPr/>
        </p:nvSpPr>
        <p:spPr>
          <a:xfrm>
            <a:off x="148448" y="422668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56680" y="44624"/>
            <a:ext cx="16594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validation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760269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49" name="组合 2048"/>
          <p:cNvGrpSpPr/>
          <p:nvPr/>
        </p:nvGrpSpPr>
        <p:grpSpPr>
          <a:xfrm>
            <a:off x="2784" y="128989"/>
            <a:ext cx="8223403" cy="6720903"/>
            <a:chOff x="-93696" y="15003"/>
            <a:chExt cx="8907318" cy="6836615"/>
          </a:xfrm>
        </p:grpSpPr>
        <p:grpSp>
          <p:nvGrpSpPr>
            <p:cNvPr id="16" name="组合 15"/>
            <p:cNvGrpSpPr/>
            <p:nvPr/>
          </p:nvGrpSpPr>
          <p:grpSpPr>
            <a:xfrm>
              <a:off x="-93696" y="15003"/>
              <a:ext cx="8907318" cy="6836615"/>
              <a:chOff x="-93696" y="15003"/>
              <a:chExt cx="8907318" cy="6836615"/>
            </a:xfrm>
          </p:grpSpPr>
          <p:grpSp>
            <p:nvGrpSpPr>
              <p:cNvPr id="12" name="组合 11"/>
              <p:cNvGrpSpPr/>
              <p:nvPr/>
            </p:nvGrpSpPr>
            <p:grpSpPr>
              <a:xfrm>
                <a:off x="-93696" y="15003"/>
                <a:ext cx="8907318" cy="6836615"/>
                <a:chOff x="-93696" y="15003"/>
                <a:chExt cx="8907318" cy="6836615"/>
              </a:xfrm>
            </p:grpSpPr>
            <p:grpSp>
              <p:nvGrpSpPr>
                <p:cNvPr id="7" name="组合 6"/>
                <p:cNvGrpSpPr/>
                <p:nvPr/>
              </p:nvGrpSpPr>
              <p:grpSpPr>
                <a:xfrm>
                  <a:off x="-93696" y="15003"/>
                  <a:ext cx="8554128" cy="6836615"/>
                  <a:chOff x="-93696" y="15003"/>
                  <a:chExt cx="8554128" cy="6836615"/>
                </a:xfrm>
              </p:grpSpPr>
              <p:pic>
                <p:nvPicPr>
                  <p:cNvPr id="2050" name="Picture 2" descr="C:\Users\zhangyanan\Desktop\48hWGCNA.PNG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-93696" y="15003"/>
                    <a:ext cx="6824802" cy="683661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6372201" y="1760180"/>
                    <a:ext cx="2088231" cy="56353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900"/>
                      </a:lnSpc>
                    </a:pPr>
                    <a:r>
                      <a:rPr lang="en-US" altLang="zh-CN" sz="8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auric</a:t>
                    </a:r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acid</a:t>
                    </a:r>
                  </a:p>
                  <a:p>
                    <a:pPr>
                      <a:lnSpc>
                        <a:spcPts val="900"/>
                      </a:lnSpc>
                    </a:pPr>
                    <a:r>
                      <a:rPr lang="en-US" altLang="zh-CN" sz="8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alose</a:t>
                    </a:r>
                    <a:endPara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>
                      <a:lnSpc>
                        <a:spcPts val="900"/>
                      </a:lnSpc>
                    </a:pPr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thyl-beta-D-</a:t>
                    </a:r>
                    <a:r>
                      <a:rPr lang="en-US" altLang="zh-CN" sz="8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alactopyranoside</a:t>
                    </a:r>
                    <a:endPara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>
                      <a:lnSpc>
                        <a:spcPts val="900"/>
                      </a:lnSpc>
                    </a:pPr>
                    <a:r>
                      <a:rPr lang="en-US" altLang="zh-CN" sz="800" dirty="0" smtClean="0">
                        <a:solidFill>
                          <a:srgbClr val="00FF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urea</a:t>
                    </a:r>
                    <a:endParaRPr lang="en-US" altLang="zh-CN" sz="800" dirty="0">
                      <a:solidFill>
                        <a:srgbClr val="00FFFF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" name="TextBox 5"/>
                  <p:cNvSpPr txBox="1"/>
                  <p:nvPr/>
                </p:nvSpPr>
                <p:spPr>
                  <a:xfrm>
                    <a:off x="6365350" y="2170817"/>
                    <a:ext cx="1519018" cy="59484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permidine</a:t>
                    </a:r>
                    <a:endPara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r>
                      <a:rPr lang="en-US" altLang="zh-CN" sz="8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eptadecanoic</a:t>
                    </a:r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acid</a:t>
                    </a:r>
                  </a:p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leic acid</a:t>
                    </a:r>
                  </a:p>
                  <a:p>
                    <a:r>
                      <a:rPr lang="en-US" altLang="zh-CN" sz="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-hydroxy-L-tryptophan</a:t>
                    </a:r>
                    <a:endPara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8" name="TextBox 7"/>
                <p:cNvSpPr txBox="1"/>
                <p:nvPr/>
              </p:nvSpPr>
              <p:spPr>
                <a:xfrm>
                  <a:off x="6365351" y="2636132"/>
                  <a:ext cx="1800200" cy="2191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L-isoleucine</a:t>
                  </a:r>
                  <a:endPara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6365351" y="2729906"/>
                  <a:ext cx="2448271" cy="2191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vl="0"/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-(+)-</a:t>
                  </a:r>
                  <a:r>
                    <a:rPr lang="en-US" altLang="zh-CN" sz="8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lactose</a:t>
                  </a:r>
                  <a:endPara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6365351" y="2823319"/>
                  <a:ext cx="1872208" cy="344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-glucose</a:t>
                  </a:r>
                </a:p>
                <a:p>
                  <a:r>
                    <a:rPr lang="en-US" altLang="zh-CN" sz="8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ioctyl</a:t>
                  </a:r>
                  <a:r>
                    <a:rPr lang="en-US" altLang="zh-CN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phthalate</a:t>
                  </a:r>
                  <a:endPara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6372198" y="3033420"/>
                  <a:ext cx="1261183" cy="2191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-glutamic acid</a:t>
                  </a:r>
                </a:p>
              </p:txBody>
            </p:sp>
          </p:grpSp>
          <p:sp>
            <p:nvSpPr>
              <p:cNvPr id="13" name="TextBox 12"/>
              <p:cNvSpPr txBox="1"/>
              <p:nvPr/>
            </p:nvSpPr>
            <p:spPr>
              <a:xfrm>
                <a:off x="6365351" y="3133417"/>
                <a:ext cx="1512168" cy="3287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50"/>
                  </a:lnSpc>
                </a:pPr>
                <a:r>
                  <a:rPr lang="en-US" altLang="zh-CN" sz="8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onic</a:t>
                </a:r>
                <a:r>
                  <a:rPr lang="en-US" altLang="zh-CN" sz="8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  <a:endParaRPr lang="zh-CN" altLang="zh-CN" sz="8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850"/>
                  </a:lnSpc>
                </a:pPr>
                <a:r>
                  <a:rPr lang="en-US" altLang="zh-CN" sz="8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threonine</a:t>
                </a:r>
                <a:endParaRPr lang="zh-CN" altLang="zh-CN" sz="8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365351" y="3356992"/>
                <a:ext cx="1787400" cy="3287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lnSpc>
                    <a:spcPts val="850"/>
                  </a:lnSpc>
                </a:pPr>
                <a:r>
                  <a:rPr lang="en-US" altLang="zh-CN" sz="8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lmitoleic</a:t>
                </a:r>
                <a:r>
                  <a:rPr lang="en-US" altLang="zh-CN" sz="8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  <a:endParaRPr lang="zh-CN" altLang="zh-CN" sz="8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lvl="0">
                  <a:lnSpc>
                    <a:spcPts val="850"/>
                  </a:lnSpc>
                </a:pPr>
                <a:r>
                  <a:rPr lang="en-US" altLang="zh-CN" sz="800" dirty="0" smtClean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-hydroxypyridine</a:t>
                </a:r>
                <a:endParaRPr lang="zh-CN" altLang="zh-CN" sz="8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365351" y="3568560"/>
                <a:ext cx="1934191" cy="5635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lnSpc>
                    <a:spcPts val="850"/>
                  </a:lnSpc>
                </a:pPr>
                <a:r>
                  <a:rPr lang="en-US" altLang="zh-CN" sz="800" dirty="0" err="1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ytol</a:t>
                </a:r>
                <a:endParaRPr lang="zh-CN" altLang="zh-CN" sz="8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lvl="0">
                  <a:lnSpc>
                    <a:spcPts val="850"/>
                  </a:lnSpc>
                </a:pPr>
                <a:r>
                  <a:rPr lang="en-US" altLang="zh-CN" sz="8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gatose</a:t>
                </a:r>
                <a:endParaRPr lang="zh-CN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lvl="0">
                  <a:lnSpc>
                    <a:spcPts val="850"/>
                  </a:lnSpc>
                </a:pPr>
                <a:r>
                  <a:rPr lang="en-US" altLang="zh-CN" sz="800" dirty="0" err="1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pric</a:t>
                </a:r>
                <a:r>
                  <a:rPr lang="en-US" altLang="zh-CN" sz="8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id</a:t>
                </a:r>
                <a:endParaRPr lang="zh-CN" altLang="zh-CN" sz="8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lvl="0">
                  <a:lnSpc>
                    <a:spcPts val="850"/>
                  </a:lnSpc>
                </a:pPr>
                <a:r>
                  <a:rPr lang="en-US" altLang="zh-CN" sz="800" dirty="0">
                    <a:solidFill>
                      <a:srgbClr val="00FF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ccinic acid</a:t>
                </a:r>
                <a:endParaRPr lang="zh-CN" altLang="zh-CN" sz="8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6365351" y="4005064"/>
              <a:ext cx="1368151" cy="3287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900"/>
                </a:lnSpc>
                <a:spcAft>
                  <a:spcPts val="0"/>
                </a:spcAft>
              </a:pPr>
              <a:r>
                <a:rPr lang="en-US" altLang="zh-CN" sz="800" kern="100" dirty="0" err="1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prylic</a:t>
              </a:r>
              <a:r>
                <a:rPr lang="en-US" altLang="zh-CN" sz="800" kern="1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  <a:endParaRPr lang="zh-CN" altLang="zh-CN" sz="800" kern="100" dirty="0">
                <a:solidFill>
                  <a:srgbClr val="00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>
                <a:lnSpc>
                  <a:spcPts val="900"/>
                </a:lnSpc>
                <a:spcAft>
                  <a:spcPts val="0"/>
                </a:spcAft>
              </a:pPr>
              <a:r>
                <a:rPr lang="en-US" altLang="zh-CN" sz="800" kern="100" dirty="0" smtClean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hydroxypyridine</a:t>
              </a:r>
              <a:endParaRPr lang="zh-CN" altLang="zh-CN" sz="800" kern="100" dirty="0">
                <a:solidFill>
                  <a:srgbClr val="00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372199" y="4221088"/>
              <a:ext cx="1008113" cy="211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yristic</a:t>
              </a:r>
              <a:r>
                <a:rPr lang="en-US" altLang="zh-CN" sz="800" kern="1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kern="100" dirty="0" smtClean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srgbClr val="00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365351" y="4324962"/>
              <a:ext cx="1001262" cy="211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cine</a:t>
              </a:r>
              <a:endParaRPr lang="zh-CN" altLang="zh-CN" sz="800" kern="100" dirty="0">
                <a:solidFill>
                  <a:srgbClr val="00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372199" y="4415695"/>
              <a:ext cx="1080120" cy="3287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srgbClr val="00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earic acid</a:t>
              </a:r>
              <a:endParaRPr lang="zh-CN" altLang="zh-CN" sz="800" kern="100" dirty="0">
                <a:solidFill>
                  <a:srgbClr val="00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noleic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362968" y="4634986"/>
              <a:ext cx="1346279" cy="211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lic 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372199" y="4738859"/>
              <a:ext cx="2013022" cy="211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900"/>
                </a:lnSpc>
                <a:spcAft>
                  <a:spcPts val="0"/>
                </a:spcAft>
              </a:pPr>
              <a:r>
                <a:rPr lang="en-US" altLang="zh-CN" sz="800" kern="100" dirty="0" smtClean="0">
                  <a:latin typeface="Times New Roman"/>
                  <a:cs typeface="Times New Roman"/>
                </a:rPr>
                <a:t>L-serine</a:t>
              </a:r>
              <a:endParaRPr lang="zh-CN" altLang="zh-CN" sz="800" kern="100" dirty="0">
                <a:cs typeface="Times New Roman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363601" y="4842733"/>
              <a:ext cx="2088231" cy="4461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srgbClr val="FF6699"/>
                  </a:solidFill>
                  <a:latin typeface="Times New Roman"/>
                  <a:cs typeface="Times New Roman"/>
                </a:rPr>
                <a:t>glycerol-1-phosphate</a:t>
              </a:r>
              <a:endParaRPr lang="zh-CN" altLang="zh-CN" sz="800" kern="100" dirty="0">
                <a:solidFill>
                  <a:srgbClr val="FF6699"/>
                </a:solidFill>
                <a:cs typeface="Times New Roman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srgbClr val="FF6699"/>
                  </a:solidFill>
                  <a:latin typeface="Times New Roman"/>
                  <a:cs typeface="Times New Roman"/>
                </a:rPr>
                <a:t>D-(+)-</a:t>
              </a:r>
              <a:r>
                <a:rPr lang="en-US" altLang="zh-CN" sz="800" kern="100" dirty="0" err="1">
                  <a:solidFill>
                    <a:srgbClr val="FF6699"/>
                  </a:solidFill>
                  <a:latin typeface="Times New Roman"/>
                  <a:cs typeface="Times New Roman"/>
                </a:rPr>
                <a:t>trehalose</a:t>
              </a:r>
              <a:endParaRPr lang="zh-CN" altLang="zh-CN" sz="800" kern="100" dirty="0">
                <a:solidFill>
                  <a:srgbClr val="FF6699"/>
                </a:solidFill>
                <a:cs typeface="Times New Roman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DL-3,4-dihydroxyphenyl-glycol</a:t>
              </a:r>
              <a:endParaRPr lang="zh-CN" altLang="zh-CN" sz="800" kern="100" dirty="0">
                <a:solidFill>
                  <a:prstClr val="black"/>
                </a:solidFill>
                <a:cs typeface="Times New Roman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357494" y="5157874"/>
              <a:ext cx="150531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sucrose</a:t>
              </a:r>
              <a:endParaRPr lang="zh-CN" altLang="zh-CN" sz="800" kern="100" dirty="0">
                <a:solidFill>
                  <a:prstClr val="black"/>
                </a:solidFill>
                <a:cs typeface="Times New Roman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357494" y="5252489"/>
              <a:ext cx="1433310" cy="4461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srgbClr val="FF6699"/>
                  </a:solidFill>
                  <a:latin typeface="Times New Roman"/>
                  <a:cs typeface="Times New Roman"/>
                </a:rPr>
                <a:t>2-hydroxybutyric acid</a:t>
              </a:r>
              <a:endParaRPr lang="zh-CN" altLang="zh-CN" sz="800" kern="100" dirty="0">
                <a:solidFill>
                  <a:srgbClr val="FF6699"/>
                </a:solidFill>
                <a:cs typeface="Times New Roman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/>
                  <a:cs typeface="Times New Roman"/>
                </a:rPr>
                <a:t>glucon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/>
                  <a:cs typeface="Times New Roman"/>
                </a:rPr>
                <a:t> acid lactone</a:t>
              </a:r>
              <a:endParaRPr lang="zh-CN" altLang="zh-CN" sz="800" kern="100" dirty="0">
                <a:solidFill>
                  <a:prstClr val="black"/>
                </a:solidFill>
                <a:cs typeface="Times New Roman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/>
                  <a:cs typeface="Times New Roman"/>
                </a:rPr>
                <a:t>benzoic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acid</a:t>
              </a:r>
              <a:endParaRPr lang="zh-CN" altLang="zh-CN" sz="800" kern="100" dirty="0">
                <a:solidFill>
                  <a:prstClr val="black"/>
                </a:solidFill>
                <a:cs typeface="Times New Roman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363601" y="5587706"/>
              <a:ext cx="92240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/>
                  <a:cs typeface="Times New Roman"/>
                </a:rPr>
                <a:t>porphine</a:t>
              </a:r>
              <a:endParaRPr lang="zh-CN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362652" y="5691068"/>
              <a:ext cx="216563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-(+)-lactic </a:t>
              </a:r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358794" y="5794942"/>
              <a:ext cx="1274588" cy="3287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</a:t>
              </a: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yroglutamic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 smtClean="0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</a:t>
              </a:r>
              <a:r>
                <a:rPr lang="en-US" altLang="zh-CN" sz="800" dirty="0" err="1" smtClean="0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rleucine</a:t>
              </a:r>
              <a:endParaRPr lang="en-US" altLang="zh-CN" sz="800" dirty="0">
                <a:solidFill>
                  <a:srgbClr val="FF6699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362652" y="6014259"/>
              <a:ext cx="2016224" cy="211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smtClean="0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-amino-1-phenylethanol</a:t>
              </a:r>
              <a:endParaRPr lang="en-US" altLang="zh-CN" sz="800" dirty="0">
                <a:solidFill>
                  <a:srgbClr val="FF6699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362652" y="6111665"/>
              <a:ext cx="1346596" cy="211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lmitic</a:t>
              </a:r>
              <a:r>
                <a:rPr lang="en-US" altLang="zh-CN" sz="800" dirty="0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 smtClean="0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solidFill>
                  <a:srgbClr val="FF6699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352550" y="6215539"/>
              <a:ext cx="1800200" cy="3287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srgbClr val="FF66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oric acid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ene-1,2,4-triol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8" name="TextBox 2047"/>
            <p:cNvSpPr txBox="1"/>
            <p:nvPr/>
          </p:nvSpPr>
          <p:spPr>
            <a:xfrm>
              <a:off x="6361925" y="6419299"/>
              <a:ext cx="1008112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lose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cerol </a:t>
              </a:r>
            </a:p>
          </p:txBody>
        </p:sp>
      </p:grpSp>
      <p:sp>
        <p:nvSpPr>
          <p:cNvPr id="2" name="右大括号 1"/>
          <p:cNvSpPr/>
          <p:nvPr/>
        </p:nvSpPr>
        <p:spPr>
          <a:xfrm>
            <a:off x="7001939" y="3294552"/>
            <a:ext cx="107965" cy="26423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右大括号 2"/>
          <p:cNvSpPr/>
          <p:nvPr/>
        </p:nvSpPr>
        <p:spPr>
          <a:xfrm>
            <a:off x="7048614" y="5993147"/>
            <a:ext cx="187682" cy="41347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20"/>
          <p:cNvSpPr txBox="1">
            <a:spLocks noChangeArrowheads="1"/>
          </p:cNvSpPr>
          <p:nvPr/>
        </p:nvSpPr>
        <p:spPr bwMode="auto">
          <a:xfrm>
            <a:off x="7222867" y="3271681"/>
            <a:ext cx="877524" cy="36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8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M5</a:t>
            </a:r>
            <a:endParaRPr kumimoji="0" lang="zh-CN" altLang="en-US" sz="1800" dirty="0" smtClean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文本框 20"/>
          <p:cNvSpPr txBox="1">
            <a:spLocks noChangeArrowheads="1"/>
          </p:cNvSpPr>
          <p:nvPr/>
        </p:nvSpPr>
        <p:spPr bwMode="auto">
          <a:xfrm>
            <a:off x="7308303" y="6014622"/>
            <a:ext cx="877524" cy="36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800" dirty="0" smtClean="0">
                <a:solidFill>
                  <a:srgbClr val="FF6699"/>
                </a:solidFill>
                <a:latin typeface="Times New Roman" pitchFamily="18" charset="0"/>
                <a:cs typeface="Times New Roman" pitchFamily="18" charset="0"/>
              </a:rPr>
              <a:t>M7</a:t>
            </a:r>
            <a:endParaRPr kumimoji="0" lang="zh-CN" altLang="en-US" sz="1800" dirty="0" smtClean="0">
              <a:solidFill>
                <a:srgbClr val="FF6699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2" name="右大括号 2051"/>
          <p:cNvSpPr/>
          <p:nvPr/>
        </p:nvSpPr>
        <p:spPr>
          <a:xfrm>
            <a:off x="6976978" y="3641108"/>
            <a:ext cx="187309" cy="95310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54" name="右大括号 2053"/>
          <p:cNvSpPr/>
          <p:nvPr/>
        </p:nvSpPr>
        <p:spPr>
          <a:xfrm>
            <a:off x="7064282" y="6460362"/>
            <a:ext cx="146614" cy="20899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20"/>
          <p:cNvSpPr txBox="1">
            <a:spLocks noChangeArrowheads="1"/>
          </p:cNvSpPr>
          <p:nvPr/>
        </p:nvSpPr>
        <p:spPr bwMode="auto">
          <a:xfrm>
            <a:off x="7222867" y="3933056"/>
            <a:ext cx="877524" cy="36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800" dirty="0" smtClean="0">
                <a:solidFill>
                  <a:srgbClr val="00FFFF"/>
                </a:solidFill>
                <a:latin typeface="Times New Roman" pitchFamily="18" charset="0"/>
                <a:cs typeface="Times New Roman" pitchFamily="18" charset="0"/>
              </a:rPr>
              <a:t>M6</a:t>
            </a:r>
            <a:endParaRPr kumimoji="0" lang="zh-CN" altLang="en-US" sz="1800" dirty="0" smtClean="0">
              <a:solidFill>
                <a:srgbClr val="00FFFF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文本框 20"/>
          <p:cNvSpPr txBox="1">
            <a:spLocks noChangeArrowheads="1"/>
          </p:cNvSpPr>
          <p:nvPr/>
        </p:nvSpPr>
        <p:spPr bwMode="auto">
          <a:xfrm>
            <a:off x="7308303" y="6393622"/>
            <a:ext cx="877524" cy="36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800" dirty="0" smtClean="0">
                <a:latin typeface="Times New Roman" pitchFamily="18" charset="0"/>
                <a:cs typeface="Times New Roman" pitchFamily="18" charset="0"/>
              </a:rPr>
              <a:t>M8</a:t>
            </a:r>
            <a:endParaRPr kumimoji="0" lang="zh-CN" altLang="en-US" sz="18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23"/>
          <p:cNvSpPr txBox="1"/>
          <p:nvPr/>
        </p:nvSpPr>
        <p:spPr>
          <a:xfrm>
            <a:off x="-54592" y="23788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S4(B)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9582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6834" y="377115"/>
            <a:ext cx="8341710" cy="6411422"/>
            <a:chOff x="665007" y="26510"/>
            <a:chExt cx="8341710" cy="6877526"/>
          </a:xfrm>
        </p:grpSpPr>
        <p:pic>
          <p:nvPicPr>
            <p:cNvPr id="3074" name="Picture 2" descr="C:\Users\zhangyanan\Desktop\72h-WGCNA.PN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5007" y="26510"/>
              <a:ext cx="5941727" cy="68775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6421621" y="1802015"/>
              <a:ext cx="211422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900"/>
                </a:lnSpc>
                <a:spcAft>
                  <a:spcPts val="0"/>
                </a:spcAft>
              </a:pPr>
              <a:r>
                <a:rPr lang="en-US" altLang="zh-CN" sz="800" kern="1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crose</a:t>
              </a:r>
              <a:endParaRPr lang="zh-CN" altLang="zh-CN" sz="8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421621" y="1911092"/>
              <a:ext cx="1656184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</a:t>
              </a: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yroglutam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agatos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-beta-D-</a:t>
              </a:r>
              <a:r>
                <a:rPr lang="en-US" altLang="zh-CN" sz="800" kern="1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alactopyranosid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421621" y="2247434"/>
              <a:ext cx="864096" cy="3466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ccinic 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421621" y="2432924"/>
              <a:ext cx="15615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-(+)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lactose</a:t>
              </a:r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900"/>
                </a:lnSpc>
              </a:pPr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-glucose</a:t>
              </a:r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421621" y="2649299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hydroxy-L-tryptophan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L-3,4-dihydroxyphenyl-glycol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421621" y="2852936"/>
              <a:ext cx="122413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lmitoleic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421621" y="2956810"/>
              <a:ext cx="102152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lonic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lic 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405379" y="3184412"/>
              <a:ext cx="769501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rphine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421621" y="3279975"/>
              <a:ext cx="194421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900"/>
                </a:lnSpc>
                <a:spcAft>
                  <a:spcPts val="0"/>
                </a:spcAft>
              </a:pPr>
              <a:r>
                <a:rPr lang="en-US" altLang="zh-CN" sz="800" kern="1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n-US" altLang="zh-CN" sz="800" kern="100" dirty="0" err="1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lose</a:t>
              </a:r>
              <a:endParaRPr lang="zh-CN" altLang="zh-CN" sz="8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421621" y="3378976"/>
              <a:ext cx="129614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ene-1,2,4-triol</a:t>
              </a:r>
              <a:endParaRPr lang="zh-CN" altLang="zh-CN" sz="8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nzoic </a:t>
              </a:r>
              <a:r>
                <a:rPr lang="en-US" altLang="zh-CN" sz="800" kern="1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421621" y="3587794"/>
              <a:ext cx="184962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-(+)-</a:t>
              </a: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ehalos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-hydroxybutyric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421621" y="3793817"/>
              <a:ext cx="146699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n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acton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421621" y="3885917"/>
              <a:ext cx="1224136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cerol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octyl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phthalat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-amino-1-phenylethanol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421621" y="4204221"/>
              <a:ext cx="120154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ytol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421621" y="4313343"/>
              <a:ext cx="175502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900"/>
                </a:lnSpc>
                <a:spcAft>
                  <a:spcPts val="0"/>
                </a:spcAft>
              </a:pPr>
              <a:r>
                <a:rPr lang="en-US" altLang="zh-CN" sz="800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hydroxypyridine</a:t>
              </a:r>
              <a:endParaRPr lang="zh-CN" altLang="zh-CN" sz="800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417374" y="4410094"/>
              <a:ext cx="166043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pr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ptadecano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417373" y="4632634"/>
              <a:ext cx="166043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lmit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hydroxypyridin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417373" y="4842384"/>
              <a:ext cx="2019633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auric</a:t>
              </a: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417373" y="4944586"/>
              <a:ext cx="1296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oric </a:t>
              </a: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417373" y="5050133"/>
              <a:ext cx="1296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414429" y="5127475"/>
              <a:ext cx="156158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lnSpc>
                  <a:spcPts val="900"/>
                </a:lnSpc>
              </a:pPr>
              <a:r>
                <a:rPr lang="en-US" altLang="zh-CN" sz="800" kern="1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cerol-1-phosphate</a:t>
              </a:r>
              <a:endParaRPr lang="zh-CN" altLang="zh-CN" sz="8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414429" y="5234626"/>
              <a:ext cx="2592288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-glutamic acid</a:t>
              </a:r>
            </a:p>
            <a:p>
              <a:pPr>
                <a:lnSpc>
                  <a:spcPts val="900"/>
                </a:lnSpc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in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oleic </a:t>
              </a:r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414429" y="5565565"/>
              <a:ext cx="2304256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earic acid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threonine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414429" y="5763127"/>
              <a:ext cx="165618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yristic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406062" y="5861864"/>
              <a:ext cx="156158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prylic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406062" y="5961502"/>
              <a:ext cx="1512168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L-isoleucine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serine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leic </a:t>
              </a: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407247" y="6302544"/>
              <a:ext cx="1451435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(+)-lactic acid</a:t>
              </a:r>
            </a:p>
            <a:p>
              <a:pPr lvl="0">
                <a:lnSpc>
                  <a:spcPts val="900"/>
                </a:lnSpc>
              </a:pPr>
              <a:r>
                <a:rPr lang="en-US" altLang="zh-CN" sz="8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</a:t>
              </a:r>
              <a:r>
                <a:rPr lang="en-US" altLang="zh-CN" sz="8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rleucine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406062" y="6493513"/>
              <a:ext cx="110695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lnSpc>
                  <a:spcPts val="900"/>
                </a:lnSpc>
              </a:pPr>
              <a:r>
                <a:rPr lang="en-US" altLang="zh-CN" sz="8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ermidine</a:t>
              </a:r>
              <a:endParaRPr lang="en-US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>
                <a:lnSpc>
                  <a:spcPts val="900"/>
                </a:lnSpc>
              </a:pP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rea</a:t>
              </a:r>
            </a:p>
          </p:txBody>
        </p:sp>
      </p:grpSp>
      <p:sp>
        <p:nvSpPr>
          <p:cNvPr id="2" name="右大括号 1"/>
          <p:cNvSpPr/>
          <p:nvPr/>
        </p:nvSpPr>
        <p:spPr>
          <a:xfrm>
            <a:off x="6660232" y="3448990"/>
            <a:ext cx="110556" cy="26804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20"/>
          <p:cNvSpPr txBox="1">
            <a:spLocks noChangeArrowheads="1"/>
          </p:cNvSpPr>
          <p:nvPr/>
        </p:nvSpPr>
        <p:spPr bwMode="auto">
          <a:xfrm>
            <a:off x="6718812" y="3356992"/>
            <a:ext cx="877524" cy="36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8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M10</a:t>
            </a:r>
            <a:endParaRPr kumimoji="0" lang="zh-CN" altLang="en-US" sz="1800" dirty="0" smtClean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右大括号 31"/>
          <p:cNvSpPr/>
          <p:nvPr/>
        </p:nvSpPr>
        <p:spPr>
          <a:xfrm>
            <a:off x="6674413" y="3234234"/>
            <a:ext cx="75231" cy="17061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20"/>
          <p:cNvSpPr txBox="1">
            <a:spLocks noChangeArrowheads="1"/>
          </p:cNvSpPr>
          <p:nvPr/>
        </p:nvSpPr>
        <p:spPr bwMode="auto">
          <a:xfrm>
            <a:off x="6718812" y="3125944"/>
            <a:ext cx="877524" cy="369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800" dirty="0" smtClean="0">
                <a:latin typeface="Times New Roman" pitchFamily="18" charset="0"/>
                <a:cs typeface="Times New Roman" pitchFamily="18" charset="0"/>
              </a:rPr>
              <a:t>M9</a:t>
            </a:r>
            <a:endParaRPr kumimoji="0" lang="zh-CN" altLang="en-US" sz="18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23"/>
          <p:cNvSpPr txBox="1"/>
          <p:nvPr/>
        </p:nvSpPr>
        <p:spPr>
          <a:xfrm>
            <a:off x="-36512" y="116632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S4(C)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768426" y="2420888"/>
            <a:ext cx="8640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ts val="900"/>
              </a:lnSpc>
            </a:pPr>
            <a:endParaRPr lang="zh-CN" altLang="zh-CN" sz="8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>
              <a:lnSpc>
                <a:spcPts val="900"/>
              </a:lnSpc>
            </a:pPr>
            <a:r>
              <a:rPr lang="en-US" altLang="zh-CN" sz="8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ose</a:t>
            </a:r>
            <a:endParaRPr lang="zh-CN" altLang="zh-CN" sz="8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624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zhangyanan\Desktop\整理胶图\slr0040-1359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469867"/>
            <a:ext cx="1440160" cy="45498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87172" y="5188859"/>
            <a:ext cx="448470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WT(F1, R3)                       2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040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04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6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04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03200" y="131566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箭头连接符 7"/>
          <p:cNvCxnSpPr>
            <a:stCxn id="6" idx="1"/>
          </p:cNvCxnSpPr>
          <p:nvPr/>
        </p:nvCxnSpPr>
        <p:spPr>
          <a:xfrm>
            <a:off x="2503200" y="1500333"/>
            <a:ext cx="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 flipH="1">
            <a:off x="2339752" y="1501211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 descr="C:\Users\zhangyanan\AppData\Roaming\Tencent\Users\851434558\QQ\WinTemp\RichOle\5C`UAZW9$090T6%MJW(G2JE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1840" y="469867"/>
            <a:ext cx="2540683" cy="45691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5868144" y="1372435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/>
          <p:cNvCxnSpPr/>
          <p:nvPr/>
        </p:nvCxnSpPr>
        <p:spPr>
          <a:xfrm flipH="1">
            <a:off x="5704696" y="1569130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900642" y="23529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79916" y="247711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 descr="C:\Users\zhangyanan\AppData\Roaming\Tencent\Users\851434558\QQ\WinTemp\RichOle\P9(@77_HEOL%3]{QK~_SJ6L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2240" y="421188"/>
            <a:ext cx="2107124" cy="4588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4" name="直接箭头连接符 23"/>
          <p:cNvCxnSpPr/>
          <p:nvPr/>
        </p:nvCxnSpPr>
        <p:spPr>
          <a:xfrm>
            <a:off x="6410755" y="1582410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819488" y="212412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35596" y="231340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448326" y="233754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136177" y="233754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572998" y="233754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007370" y="203630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496436" y="208403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左大括号 1"/>
          <p:cNvSpPr/>
          <p:nvPr/>
        </p:nvSpPr>
        <p:spPr>
          <a:xfrm rot="16200000">
            <a:off x="1262048" y="1353343"/>
            <a:ext cx="184974" cy="591873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左大括号 21"/>
          <p:cNvSpPr/>
          <p:nvPr/>
        </p:nvSpPr>
        <p:spPr>
          <a:xfrm rot="16200000">
            <a:off x="3391488" y="1415803"/>
            <a:ext cx="184974" cy="591873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左大括号 22"/>
          <p:cNvSpPr/>
          <p:nvPr/>
        </p:nvSpPr>
        <p:spPr>
          <a:xfrm rot="16200000">
            <a:off x="8330060" y="1505743"/>
            <a:ext cx="184974" cy="591873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4432" y="9921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44606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zhangyanan\Desktop\修图\2\3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4579" y="347646"/>
            <a:ext cx="4200525" cy="4476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4057" y="767955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箭头连接符 5"/>
          <p:cNvCxnSpPr/>
          <p:nvPr/>
        </p:nvCxnSpPr>
        <p:spPr>
          <a:xfrm>
            <a:off x="636668" y="977930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031597" y="134564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20592" y="13487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14090" y="134873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56460" y="4899071"/>
            <a:ext cx="7961293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2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r2857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)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689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49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8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834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10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004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12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95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14710" y="-42374"/>
            <a:ext cx="4907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1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89061" y="131985"/>
            <a:ext cx="6580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809136" y="133330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238242" y="133330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637721" y="133330"/>
            <a:ext cx="826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392978" y="133330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7</a:t>
            </a:r>
            <a:endParaRPr lang="zh-CN" alt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5" name="Picture 1" descr="C:\Users\zhangyanan\AppData\Roaming\Tencent\Users\851434558\QQ\WinTemp\RichOle\GMQN@DQ8OZUXSI}}P(_B`BI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2119" y="349353"/>
            <a:ext cx="2424907" cy="44767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5684235" y="132133"/>
            <a:ext cx="413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129730" y="128557"/>
            <a:ext cx="413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316416" y="116833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 flipH="1">
            <a:off x="8152968" y="1365031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左大括号 20"/>
          <p:cNvSpPr/>
          <p:nvPr/>
        </p:nvSpPr>
        <p:spPr>
          <a:xfrm rot="16200000">
            <a:off x="1523507" y="1127141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左大括号 21"/>
          <p:cNvSpPr/>
          <p:nvPr/>
        </p:nvSpPr>
        <p:spPr>
          <a:xfrm rot="16200000">
            <a:off x="3139869" y="1074688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左大括号 22"/>
          <p:cNvSpPr/>
          <p:nvPr/>
        </p:nvSpPr>
        <p:spPr>
          <a:xfrm rot="16200000">
            <a:off x="3640982" y="1074688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左大括号 23"/>
          <p:cNvSpPr/>
          <p:nvPr/>
        </p:nvSpPr>
        <p:spPr>
          <a:xfrm rot="16200000">
            <a:off x="4769014" y="1089678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左大括号 25"/>
          <p:cNvSpPr/>
          <p:nvPr/>
        </p:nvSpPr>
        <p:spPr>
          <a:xfrm rot="16200000">
            <a:off x="5999586" y="1248413"/>
            <a:ext cx="184974" cy="591873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1657008" y="129043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40190" y="131622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大括号 28"/>
          <p:cNvSpPr/>
          <p:nvPr/>
        </p:nvSpPr>
        <p:spPr>
          <a:xfrm rot="16200000">
            <a:off x="1987740" y="1116716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9"/>
          <p:cNvSpPr txBox="1"/>
          <p:nvPr/>
        </p:nvSpPr>
        <p:spPr>
          <a:xfrm>
            <a:off x="7641306" y="131622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4432" y="9921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9433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 descr="C:\Users\zhangyanan\AppData\Roaming\Tencent\Users\851434558\QQ\WinTemp\RichOle\~1@2FV)%]~$ZTA25F0LG6JQ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8488" y="909138"/>
            <a:ext cx="1833977" cy="4392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组合 3"/>
          <p:cNvGrpSpPr/>
          <p:nvPr/>
        </p:nvGrpSpPr>
        <p:grpSpPr>
          <a:xfrm>
            <a:off x="107505" y="1759369"/>
            <a:ext cx="1080118" cy="369332"/>
            <a:chOff x="185313" y="1471337"/>
            <a:chExt cx="916857" cy="369332"/>
          </a:xfrm>
        </p:grpSpPr>
        <p:sp>
          <p:nvSpPr>
            <p:cNvPr id="5" name="TextBox 4"/>
            <p:cNvSpPr txBox="1"/>
            <p:nvPr/>
          </p:nvSpPr>
          <p:spPr>
            <a:xfrm>
              <a:off x="185313" y="1471337"/>
              <a:ext cx="9168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k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箭头连接符 5"/>
            <p:cNvCxnSpPr/>
            <p:nvPr/>
          </p:nvCxnSpPr>
          <p:spPr>
            <a:xfrm>
              <a:off x="661662" y="1681312"/>
              <a:ext cx="238043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矩形 6"/>
          <p:cNvSpPr/>
          <p:nvPr/>
        </p:nvSpPr>
        <p:spPr>
          <a:xfrm>
            <a:off x="895535" y="5363924"/>
            <a:ext cx="30283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WT (F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512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WT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4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0889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31597" y="692696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305080" y="693005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28501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 descr="C:\Users\zhangyanan\AppData\Roaming\Tencent\Users\851434558\QQ\WinTemp\RichOle\B6C(4CC8X(YKS6TK6Q%(3FD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6766" y="909138"/>
            <a:ext cx="1401298" cy="4289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2896119" y="1938663"/>
            <a:ext cx="1080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/>
          <p:cNvCxnSpPr/>
          <p:nvPr/>
        </p:nvCxnSpPr>
        <p:spPr>
          <a:xfrm>
            <a:off x="3457290" y="2148638"/>
            <a:ext cx="280430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000126" y="706143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513439" y="710626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820567" y="706143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Picture 1" descr="C:\Users\zhangyanan\AppData\Roaming\Tencent\Users\851434558\QQ\WinTemp\RichOle\_~MMSP%NL~]A2JE~8TZCP`H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921014"/>
            <a:ext cx="2376264" cy="43081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8551872" y="191567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>
          <a:xfrm flipH="1">
            <a:off x="8388424" y="2112374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827600" y="70021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445104" y="710072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145128" y="70976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137394" y="704990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7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755576" y="5647600"/>
            <a:ext cx="48590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113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primer)    6:WT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    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slr111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Cm-R2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31" name="左大括号 30"/>
          <p:cNvSpPr/>
          <p:nvPr/>
        </p:nvSpPr>
        <p:spPr>
          <a:xfrm rot="16200000">
            <a:off x="2347780" y="1996868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左大括号 31"/>
          <p:cNvSpPr/>
          <p:nvPr/>
        </p:nvSpPr>
        <p:spPr>
          <a:xfrm rot="16200000">
            <a:off x="4451003" y="2196836"/>
            <a:ext cx="184977" cy="37503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左大括号 32"/>
          <p:cNvSpPr/>
          <p:nvPr/>
        </p:nvSpPr>
        <p:spPr>
          <a:xfrm rot="16200000">
            <a:off x="6799255" y="1754713"/>
            <a:ext cx="184980" cy="1235184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4432" y="9921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81514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1" descr="C:\Users\zhangyanan\AppData\Roaming\Tencent\Users\851434558\QQ\WinTemp\RichOle\~W7YU2OH`)6SO4M_C@D6A38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898400"/>
            <a:ext cx="6211178" cy="34667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8214534" y="674318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21285" y="692229"/>
            <a:ext cx="826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80274" y="68144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8" name="Picture 2" descr="C:\Users\zhangyanan\AppData\Roaming\Tencent\Users\851434558\QQ\WinTemp\RichOle\CNK{YRW9G]$_((VXSXS}8KP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906" y="898400"/>
            <a:ext cx="1506165" cy="34667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705689" y="688708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648965" y="692538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96656" y="69017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28704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58175" y="684258"/>
            <a:ext cx="548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513439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46521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993000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59989" y="692696"/>
            <a:ext cx="536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014559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324712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558956" y="69269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839073" y="692696"/>
            <a:ext cx="402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72903" y="4581128"/>
            <a:ext cx="1209734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27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2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31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WT(F1, R3)                                  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31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)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145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)</a:t>
            </a:r>
            <a:r>
              <a:rPr lang="zh-CN" altLang="en-US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:WT(F1, R3)     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149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10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0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1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16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1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</a:p>
          <a:p>
            <a:endParaRPr lang="en-US" altLang="zh-C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-86401" y="1511678"/>
            <a:ext cx="1080118" cy="338554"/>
            <a:chOff x="230969" y="1484784"/>
            <a:chExt cx="916857" cy="338554"/>
          </a:xfrm>
        </p:grpSpPr>
        <p:sp>
          <p:nvSpPr>
            <p:cNvPr id="24" name="TextBox 23"/>
            <p:cNvSpPr txBox="1"/>
            <p:nvPr/>
          </p:nvSpPr>
          <p:spPr>
            <a:xfrm>
              <a:off x="230969" y="1484784"/>
              <a:ext cx="9168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kb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直接箭头连接符 24"/>
            <p:cNvCxnSpPr/>
            <p:nvPr/>
          </p:nvCxnSpPr>
          <p:spPr>
            <a:xfrm>
              <a:off x="643742" y="1681312"/>
              <a:ext cx="249827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Box 27"/>
          <p:cNvSpPr txBox="1"/>
          <p:nvPr/>
        </p:nvSpPr>
        <p:spPr>
          <a:xfrm>
            <a:off x="8673427" y="1727067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箭头连接符 28"/>
          <p:cNvCxnSpPr/>
          <p:nvPr/>
        </p:nvCxnSpPr>
        <p:spPr>
          <a:xfrm flipH="1">
            <a:off x="8555707" y="1903385"/>
            <a:ext cx="196385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8669946" y="1556792"/>
            <a:ext cx="9164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箭头连接符 30"/>
          <p:cNvCxnSpPr/>
          <p:nvPr/>
        </p:nvCxnSpPr>
        <p:spPr>
          <a:xfrm flipH="1">
            <a:off x="8533296" y="1733110"/>
            <a:ext cx="196385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左大括号 31"/>
          <p:cNvSpPr/>
          <p:nvPr/>
        </p:nvSpPr>
        <p:spPr>
          <a:xfrm rot="16200000">
            <a:off x="1235371" y="1730621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左大括号 32"/>
          <p:cNvSpPr/>
          <p:nvPr/>
        </p:nvSpPr>
        <p:spPr>
          <a:xfrm rot="16200000">
            <a:off x="1808493" y="1725069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左大括号 33"/>
          <p:cNvSpPr/>
          <p:nvPr/>
        </p:nvSpPr>
        <p:spPr>
          <a:xfrm rot="16200000">
            <a:off x="2531515" y="1857038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左大括号 34"/>
          <p:cNvSpPr/>
          <p:nvPr/>
        </p:nvSpPr>
        <p:spPr>
          <a:xfrm rot="16200000">
            <a:off x="4676765" y="1668052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左大括号 35"/>
          <p:cNvSpPr/>
          <p:nvPr/>
        </p:nvSpPr>
        <p:spPr>
          <a:xfrm rot="16200000">
            <a:off x="5210801" y="1680100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左大括号 36"/>
          <p:cNvSpPr/>
          <p:nvPr/>
        </p:nvSpPr>
        <p:spPr>
          <a:xfrm rot="16200000">
            <a:off x="6275931" y="1683042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左大括号 37"/>
          <p:cNvSpPr/>
          <p:nvPr/>
        </p:nvSpPr>
        <p:spPr>
          <a:xfrm rot="16200000">
            <a:off x="6807025" y="1683042"/>
            <a:ext cx="135522" cy="37503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1"/>
          <p:cNvSpPr txBox="1"/>
          <p:nvPr/>
        </p:nvSpPr>
        <p:spPr>
          <a:xfrm>
            <a:off x="6590026" y="4737019"/>
            <a:ext cx="3332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</a:t>
            </a:r>
            <a:endParaRPr lang="zh-CN" altLang="en-US" sz="900" dirty="0"/>
          </a:p>
        </p:txBody>
      </p:sp>
      <p:sp>
        <p:nvSpPr>
          <p:cNvPr id="39" name="矩形 38"/>
          <p:cNvSpPr/>
          <p:nvPr/>
        </p:nvSpPr>
        <p:spPr>
          <a:xfrm>
            <a:off x="4432" y="9921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61257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zhangyanan\Desktop\修图\2\067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072" y="179585"/>
            <a:ext cx="5000469" cy="23698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-61053" y="40751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箭头连接符 7"/>
          <p:cNvCxnSpPr/>
          <p:nvPr/>
        </p:nvCxnSpPr>
        <p:spPr>
          <a:xfrm>
            <a:off x="481558" y="589524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521425" y="-3658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75408" y="-50033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31391" y="-3073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99973" y="253138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02550" y="2533581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3" name="Picture 3" descr="C:\Users\zhangyanan\AppData\Roaming\Tencent\Users\851434558\QQ\WinTemp\RichOle\5}_A0YG2G%1KRZMQCHN)ZW5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821" y="2736158"/>
            <a:ext cx="5014721" cy="24345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zhangyanan\AppData\Roaming\Tencent\Users\851434558\QQ\WinTemp\RichOle\{3NQG9_H6XQ{%PA`MEYOZPT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0192" y="179585"/>
            <a:ext cx="786990" cy="2360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697015" y="253116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-56570" y="333459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/>
          <p:cNvCxnSpPr/>
          <p:nvPr/>
        </p:nvCxnSpPr>
        <p:spPr>
          <a:xfrm>
            <a:off x="486041" y="3531125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43813" y="5229200"/>
            <a:ext cx="9036495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1104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2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1104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primer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314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   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1314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)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8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428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1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10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11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428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zh-CN" altLang="en-US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primer)</a:t>
            </a:r>
            <a:r>
              <a:rPr lang="zh-CN" altLang="en-US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nal primer)</a:t>
            </a:r>
            <a:r>
              <a: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9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143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15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143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1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)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67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8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598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20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    21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598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22:WT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237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2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    25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237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3)         26:WT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341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28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endParaRPr lang="en-US" altLang="zh-CN" sz="9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145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30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14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32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l018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3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</a:p>
          <a:p>
            <a:endParaRPr lang="en-US" altLang="zh-CN" sz="900" b="1" dirty="0">
              <a:solidFill>
                <a:srgbClr val="FF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900" b="1" dirty="0">
              <a:solidFill>
                <a:srgbClr val="CC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009005" y="-3658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216355" y="-3181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734419" y="2535940"/>
            <a:ext cx="5499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  8 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915816" y="-3181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08557" y="-3658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528882" y="253225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708176" y="2538354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7" name="Picture 7" descr="C:\Users\zhangyanan\AppData\Roaming\Tencent\Users\851434558\QQ\WinTemp\RichOle\VW~AHC044UY6@3IX8ASN1Z8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1406" y="2771319"/>
            <a:ext cx="1572961" cy="23717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8028384" y="405378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箭头连接符 30"/>
          <p:cNvCxnSpPr/>
          <p:nvPr/>
        </p:nvCxnSpPr>
        <p:spPr>
          <a:xfrm flipH="1">
            <a:off x="7910664" y="4230106"/>
            <a:ext cx="196385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6256871" y="-3422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512674" y="2558061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11401" y="-3658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800531" y="-3658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329485" y="256843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937216" y="2566078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991163" y="-342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210798" y="-3181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947886" y="-3658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 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195577" y="-29454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94076" y="253116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486817" y="253594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473501" y="-2581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760371" y="-2822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310300" y="253239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503041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 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123728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328704" y="253595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891321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097509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-56570" y="311087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直接箭头连接符 53"/>
          <p:cNvCxnSpPr/>
          <p:nvPr/>
        </p:nvCxnSpPr>
        <p:spPr>
          <a:xfrm>
            <a:off x="486041" y="3320848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-52087" y="290296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直接箭头连接符 55"/>
          <p:cNvCxnSpPr/>
          <p:nvPr/>
        </p:nvCxnSpPr>
        <p:spPr>
          <a:xfrm>
            <a:off x="490524" y="3096150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065570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285205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875878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095513" y="2534809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左大括号 60"/>
          <p:cNvSpPr/>
          <p:nvPr/>
        </p:nvSpPr>
        <p:spPr>
          <a:xfrm rot="16200000">
            <a:off x="1706179" y="596125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左大括号 61"/>
          <p:cNvSpPr/>
          <p:nvPr/>
        </p:nvSpPr>
        <p:spPr>
          <a:xfrm rot="16200000">
            <a:off x="2172289" y="604676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左大括号 62"/>
          <p:cNvSpPr/>
          <p:nvPr/>
        </p:nvSpPr>
        <p:spPr>
          <a:xfrm rot="16200000">
            <a:off x="1521852" y="3567190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左大括号 63"/>
          <p:cNvSpPr/>
          <p:nvPr/>
        </p:nvSpPr>
        <p:spPr>
          <a:xfrm rot="16200000">
            <a:off x="1879453" y="3569690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左大括号 64"/>
          <p:cNvSpPr/>
          <p:nvPr/>
        </p:nvSpPr>
        <p:spPr>
          <a:xfrm rot="16200000">
            <a:off x="3105451" y="622166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左大括号 65"/>
          <p:cNvSpPr/>
          <p:nvPr/>
        </p:nvSpPr>
        <p:spPr>
          <a:xfrm rot="16200000">
            <a:off x="2728560" y="3662130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左大括号 66"/>
          <p:cNvSpPr/>
          <p:nvPr/>
        </p:nvSpPr>
        <p:spPr>
          <a:xfrm rot="16200000">
            <a:off x="3768512" y="619666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左大括号 67"/>
          <p:cNvSpPr/>
          <p:nvPr/>
        </p:nvSpPr>
        <p:spPr>
          <a:xfrm rot="16200000">
            <a:off x="6744390" y="4405718"/>
            <a:ext cx="154534" cy="541247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左大括号 68"/>
          <p:cNvSpPr/>
          <p:nvPr/>
        </p:nvSpPr>
        <p:spPr>
          <a:xfrm rot="16200000">
            <a:off x="4245445" y="625707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左大括号 69"/>
          <p:cNvSpPr/>
          <p:nvPr/>
        </p:nvSpPr>
        <p:spPr>
          <a:xfrm rot="16200000">
            <a:off x="5167597" y="619190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左大括号 70"/>
          <p:cNvSpPr/>
          <p:nvPr/>
        </p:nvSpPr>
        <p:spPr>
          <a:xfrm rot="16200000">
            <a:off x="3526648" y="3667750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2" name="左大括号 71"/>
          <p:cNvSpPr/>
          <p:nvPr/>
        </p:nvSpPr>
        <p:spPr>
          <a:xfrm rot="16200000">
            <a:off x="6737259" y="800618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3" name="左大括号 72"/>
          <p:cNvSpPr/>
          <p:nvPr/>
        </p:nvSpPr>
        <p:spPr>
          <a:xfrm rot="16200000">
            <a:off x="5514406" y="3675010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左大括号 73"/>
          <p:cNvSpPr/>
          <p:nvPr/>
        </p:nvSpPr>
        <p:spPr>
          <a:xfrm rot="16200000">
            <a:off x="2317588" y="3480193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左大括号 74"/>
          <p:cNvSpPr/>
          <p:nvPr/>
        </p:nvSpPr>
        <p:spPr>
          <a:xfrm rot="16200000">
            <a:off x="3118104" y="3415264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左大括号 75"/>
          <p:cNvSpPr/>
          <p:nvPr/>
        </p:nvSpPr>
        <p:spPr>
          <a:xfrm rot="16200000">
            <a:off x="4332688" y="3422698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左大括号 76"/>
          <p:cNvSpPr/>
          <p:nvPr/>
        </p:nvSpPr>
        <p:spPr>
          <a:xfrm rot="16200000">
            <a:off x="5125338" y="3408185"/>
            <a:ext cx="122984" cy="22154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/>
          <p:cNvSpPr/>
          <p:nvPr/>
        </p:nvSpPr>
        <p:spPr>
          <a:xfrm>
            <a:off x="4432" y="-50912"/>
            <a:ext cx="4796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340802" y="-31445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436096" y="-27384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47092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C:\Users\zhangyanan\AppData\Roaming\Tencent\Users\851434558\QQ\WinTemp\RichOle\(Y36H1B78F2F%MMEB~}{0D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222" y="644098"/>
            <a:ext cx="933450" cy="3571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781908" y="127743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箭头连接符 5"/>
          <p:cNvCxnSpPr/>
          <p:nvPr/>
        </p:nvCxnSpPr>
        <p:spPr>
          <a:xfrm flipH="1">
            <a:off x="1618460" y="1474129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77293" y="44798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09567" y="440232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74872" y="431558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80496" y="4471944"/>
            <a:ext cx="8349899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108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2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005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0146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 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)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8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49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6" name="Picture 2" descr="C:\Users\zhangyanan\AppData\Roaming\Tencent\Users\851434558\QQ\WinTemp\RichOle\%NR}1G5UDN@GOVEXM0U6Z_6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9877" y="748873"/>
            <a:ext cx="1819275" cy="3467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2706358" y="54361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58330" y="538844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418370" y="54626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813978" y="548680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176392" y="53971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7" name="Picture 3" descr="C:\Users\zhangyanan\AppData\Roaming\Tencent\Users\851434558\QQ\WinTemp\RichOle\GK}8_~NH5VS%$MC5YYNDBZY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6209" y="771883"/>
            <a:ext cx="3290247" cy="3444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直接箭头连接符 17"/>
          <p:cNvCxnSpPr/>
          <p:nvPr/>
        </p:nvCxnSpPr>
        <p:spPr>
          <a:xfrm>
            <a:off x="2357972" y="1457890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499992" y="132225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箭头连接符 21"/>
          <p:cNvCxnSpPr/>
          <p:nvPr/>
        </p:nvCxnSpPr>
        <p:spPr>
          <a:xfrm>
            <a:off x="5076056" y="1502714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089344" y="55971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370204" y="5621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64088" y="56154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左大括号 25"/>
          <p:cNvSpPr/>
          <p:nvPr/>
        </p:nvSpPr>
        <p:spPr>
          <a:xfrm rot="16200000">
            <a:off x="944071" y="1461337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左大括号 26"/>
          <p:cNvSpPr/>
          <p:nvPr/>
        </p:nvSpPr>
        <p:spPr>
          <a:xfrm rot="16200000">
            <a:off x="3370026" y="1372296"/>
            <a:ext cx="122984" cy="53404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左大括号 27"/>
          <p:cNvSpPr/>
          <p:nvPr/>
        </p:nvSpPr>
        <p:spPr>
          <a:xfrm rot="16200000">
            <a:off x="4122493" y="1400252"/>
            <a:ext cx="122984" cy="53404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左大括号 28"/>
          <p:cNvSpPr/>
          <p:nvPr/>
        </p:nvSpPr>
        <p:spPr>
          <a:xfrm rot="16200000">
            <a:off x="8288887" y="1495985"/>
            <a:ext cx="122984" cy="355958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4432" y="99216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97928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69" name="Picture 1" descr="C:\Users\zhangyanan\AppData\Roaming\Tencent\Users\851434558\QQ\WinTemp\RichOle\YLTV7X{YMSMY_J_345$Y(4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66" y="764704"/>
            <a:ext cx="1028700" cy="30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36952" y="553815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09567" y="559713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01766" y="564486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0573" y="4149080"/>
            <a:ext cx="83498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1082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2:WT(F1, R3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l1453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WT(internal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, R3)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r1224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1248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:</a:t>
            </a:r>
            <a:r>
              <a:rPr lang="en-US" altLang="zh-CN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△slr0949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 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zh-CN" alt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:WT(F1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ternal primer)</a:t>
            </a: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35696" y="127743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箭头连接符 9"/>
          <p:cNvCxnSpPr/>
          <p:nvPr/>
        </p:nvCxnSpPr>
        <p:spPr>
          <a:xfrm flipH="1">
            <a:off x="1672248" y="1474129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AutoShape 2" descr="C:\Users\zhangyanan\AppData\Roaming\Tencent\Users\851434558\QQ\WinTemp\RichOle\TY~2XORN~T%FKZFIGK8P.png"/>
          <p:cNvSpPr>
            <a:spLocks noChangeAspect="1" noChangeArrowheads="1"/>
          </p:cNvSpPr>
          <p:nvPr/>
        </p:nvSpPr>
        <p:spPr bwMode="auto">
          <a:xfrm>
            <a:off x="0" y="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4" name="AutoShape 5" descr="C:\Users\zhangyanan\AppData\Roaming\Tencent\Users\851434558\QQ\WinTemp\RichOle\TY~2XORN~T%FKZFIGK8P.png"/>
          <p:cNvSpPr>
            <a:spLocks noChangeAspect="1" noChangeArrowheads="1"/>
          </p:cNvSpPr>
          <p:nvPr/>
        </p:nvSpPr>
        <p:spPr bwMode="auto">
          <a:xfrm>
            <a:off x="313184" y="4572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8168" y="762000"/>
            <a:ext cx="3075608" cy="30507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2134072" y="187171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>
            <a:off x="2676683" y="2068246"/>
            <a:ext cx="288032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053749" y="56212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419168" y="5621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29321" y="5621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793929" y="5621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080125" y="558226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440165" y="5621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777212" y="562127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8264" y="798531"/>
            <a:ext cx="1389211" cy="301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7" name="直接箭头连接符 26"/>
          <p:cNvCxnSpPr/>
          <p:nvPr/>
        </p:nvCxnSpPr>
        <p:spPr>
          <a:xfrm flipH="1">
            <a:off x="8368992" y="1868575"/>
            <a:ext cx="216024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8518993" y="1677815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937216" y="589021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382711" y="589021"/>
            <a:ext cx="443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endParaRPr lang="zh-CN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839254" y="580057"/>
            <a:ext cx="272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左大括号 31"/>
          <p:cNvSpPr/>
          <p:nvPr/>
        </p:nvSpPr>
        <p:spPr>
          <a:xfrm rot="16200000">
            <a:off x="869999" y="1512707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左大括号 32"/>
          <p:cNvSpPr/>
          <p:nvPr/>
        </p:nvSpPr>
        <p:spPr>
          <a:xfrm rot="16200000">
            <a:off x="3678311" y="2032804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左大括号 33"/>
          <p:cNvSpPr/>
          <p:nvPr/>
        </p:nvSpPr>
        <p:spPr>
          <a:xfrm rot="16200000">
            <a:off x="5007379" y="1936082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左大括号 34"/>
          <p:cNvSpPr/>
          <p:nvPr/>
        </p:nvSpPr>
        <p:spPr>
          <a:xfrm rot="16200000">
            <a:off x="5667808" y="2178954"/>
            <a:ext cx="122984" cy="442392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左大括号 35"/>
          <p:cNvSpPr/>
          <p:nvPr/>
        </p:nvSpPr>
        <p:spPr>
          <a:xfrm rot="16200000">
            <a:off x="7294853" y="1967354"/>
            <a:ext cx="88048" cy="513640"/>
          </a:xfrm>
          <a:prstGeom prst="leftBrac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4432" y="99216"/>
            <a:ext cx="5180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5050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8D9DE7CD2E9E54495CEF995A9FBEE2B" ma:contentTypeVersion="7" ma:contentTypeDescription="Create a new document." ma:contentTypeScope="" ma:versionID="430dd56235e626b7aca02e0f15b3a0a0">
  <xsd:schema xmlns:xsd="http://www.w3.org/2001/XMLSchema" xmlns:p="http://schemas.microsoft.com/office/2006/metadata/properties" xmlns:ns2="d66a66c9-44e3-46d1-b0e5-b9cef715d00f" targetNamespace="http://schemas.microsoft.com/office/2006/metadata/properties" ma:root="true" ma:fieldsID="285fb956542713b513b7cc3f5710afc9" ns2:_="">
    <xsd:import namespace="d66a66c9-44e3-46d1-b0e5-b9cef715d00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66a66c9-44e3-46d1-b0e5-b9cef715d00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d66a66c9-44e3-46d1-b0e5-b9cef715d00f">Presentation 1.PPTX</DocumentId>
    <IsDeleted xmlns="d66a66c9-44e3-46d1-b0e5-b9cef715d00f">false</IsDeleted>
    <TitleName xmlns="d66a66c9-44e3-46d1-b0e5-b9cef715d00f">Presentation 1.PPTX</TitleName>
    <StageName xmlns="d66a66c9-44e3-46d1-b0e5-b9cef715d00f" xsi:nil="true"/>
    <Checked_x0020_Out_x0020_To xmlns="d66a66c9-44e3-46d1-b0e5-b9cef715d00f">
      <UserInfo>
        <DisplayName/>
        <AccountId xsi:nil="true"/>
        <AccountType/>
      </UserInfo>
    </Checked_x0020_Out_x0020_To>
    <DocumentType xmlns="d66a66c9-44e3-46d1-b0e5-b9cef715d00f">Presentation</DocumentType>
    <FileFormat xmlns="d66a66c9-44e3-46d1-b0e5-b9cef715d00f">PPTX</FileFormat>
  </documentManagement>
</p:properties>
</file>

<file path=customXml/itemProps1.xml><?xml version="1.0" encoding="utf-8"?>
<ds:datastoreItem xmlns:ds="http://schemas.openxmlformats.org/officeDocument/2006/customXml" ds:itemID="{398BDC36-E3AE-47AD-90B1-08FFE1D5B3D4}"/>
</file>

<file path=customXml/itemProps2.xml><?xml version="1.0" encoding="utf-8"?>
<ds:datastoreItem xmlns:ds="http://schemas.openxmlformats.org/officeDocument/2006/customXml" ds:itemID="{DA584E5B-FE0A-4F8E-A91C-5D355BAEBF55}"/>
</file>

<file path=customXml/itemProps3.xml><?xml version="1.0" encoding="utf-8"?>
<ds:datastoreItem xmlns:ds="http://schemas.openxmlformats.org/officeDocument/2006/customXml" ds:itemID="{16E58074-353B-458B-B342-C5991AEA6392}"/>
</file>

<file path=docProps/app.xml><?xml version="1.0" encoding="utf-8"?>
<Properties xmlns="http://schemas.openxmlformats.org/officeDocument/2006/extended-properties" xmlns:vt="http://schemas.openxmlformats.org/officeDocument/2006/docPropsVTypes">
  <TotalTime>16186</TotalTime>
  <Words>1895</Words>
  <Application>Microsoft Office PowerPoint</Application>
  <PresentationFormat>全屏显示(4:3)</PresentationFormat>
  <Paragraphs>639</Paragraphs>
  <Slides>21</Slides>
  <Notes>3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1</vt:i4>
      </vt:variant>
    </vt:vector>
  </HeadingPairs>
  <TitlesOfParts>
    <vt:vector size="22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yanan</dc:creator>
  <cp:lastModifiedBy>zhangyanan</cp:lastModifiedBy>
  <cp:revision>272</cp:revision>
  <dcterms:created xsi:type="dcterms:W3CDTF">2014-05-14T06:54:27Z</dcterms:created>
  <dcterms:modified xsi:type="dcterms:W3CDTF">2015-04-30T03:23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8D9DE7CD2E9E54495CEF995A9FBEE2B</vt:lpwstr>
  </property>
</Properties>
</file>